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2.xml" ContentType="application/vnd.openxmlformats-officedocument.theme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theme/theme3.xml" ContentType="application/vnd.openxmlformats-officedocument.theme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theme/theme4.xml" ContentType="application/vnd.openxmlformats-officedocument.theme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theme/theme5.xml" ContentType="application/vnd.openxmlformats-officedocument.theme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theme/theme6.xml" ContentType="application/vnd.openxmlformats-officedocument.theme+xml"/>
  <Override PartName="/ppt/slideLayouts/slideLayout79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90.xml" ContentType="application/vnd.openxmlformats-officedocument.presentationml.slideLayout+xml"/>
  <Override PartName="/ppt/theme/theme7.xml" ContentType="application/vnd.openxmlformats-officedocument.theme+xml"/>
  <Override PartName="/ppt/theme/theme8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5" r:id="rId4"/>
    <p:sldMasterId id="2147483758" r:id="rId5"/>
    <p:sldMasterId id="2147483775" r:id="rId6"/>
    <p:sldMasterId id="2147483787" r:id="rId7"/>
    <p:sldMasterId id="2147483800" r:id="rId8"/>
    <p:sldMasterId id="2147483817" r:id="rId9"/>
    <p:sldMasterId id="2147483829" r:id="rId10"/>
  </p:sldMasterIdLst>
  <p:notesMasterIdLst>
    <p:notesMasterId r:id="rId21"/>
  </p:notesMasterIdLst>
  <p:sldIdLst>
    <p:sldId id="258" r:id="rId11"/>
    <p:sldId id="259" r:id="rId12"/>
    <p:sldId id="260" r:id="rId13"/>
    <p:sldId id="261" r:id="rId14"/>
    <p:sldId id="262" r:id="rId15"/>
    <p:sldId id="263" r:id="rId16"/>
    <p:sldId id="264" r:id="rId17"/>
    <p:sldId id="265" r:id="rId18"/>
    <p:sldId id="266" r:id="rId19"/>
    <p:sldId id="267" r:id="rId20"/>
  </p:sldIdLst>
  <p:sldSz cx="12192000" cy="6858000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Trebuchet MS" panose="020B0603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Trebuchet MS" panose="020B0603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Trebuchet MS" panose="020B0603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Trebuchet MS" panose="020B0603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Trebuchet MS" panose="020B0603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Trebuchet MS" panose="020B0603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Trebuchet MS" panose="020B0603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Trebuchet MS" panose="020B0603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Trebuchet MS" panose="020B0603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A0F8A8D-1678-4F2C-ABCC-C272920BD3F7}" v="5" dt="2022-02-03T21:35:59.6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1733" autoAdjust="0"/>
  </p:normalViewPr>
  <p:slideViewPr>
    <p:cSldViewPr snapToGrid="0">
      <p:cViewPr varScale="1">
        <p:scale>
          <a:sx n="68" d="100"/>
          <a:sy n="68" d="100"/>
        </p:scale>
        <p:origin x="66" y="21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5.xml"/><Relationship Id="rId13" Type="http://schemas.openxmlformats.org/officeDocument/2006/relationships/slide" Target="slides/slide3.xml"/><Relationship Id="rId18" Type="http://schemas.openxmlformats.org/officeDocument/2006/relationships/slide" Target="slides/slide8.xml"/><Relationship Id="rId26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21" Type="http://schemas.openxmlformats.org/officeDocument/2006/relationships/notesMaster" Target="notesMasters/notesMaster1.xml"/><Relationship Id="rId7" Type="http://schemas.openxmlformats.org/officeDocument/2006/relationships/slideMaster" Target="slideMasters/slideMaster4.xml"/><Relationship Id="rId12" Type="http://schemas.openxmlformats.org/officeDocument/2006/relationships/slide" Target="slides/slide2.xml"/><Relationship Id="rId17" Type="http://schemas.openxmlformats.org/officeDocument/2006/relationships/slide" Target="slides/slide7.xml"/><Relationship Id="rId25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6.xml"/><Relationship Id="rId20" Type="http://schemas.openxmlformats.org/officeDocument/2006/relationships/slide" Target="slides/slide10.xml"/><Relationship Id="rId1" Type="http://schemas.openxmlformats.org/officeDocument/2006/relationships/customXml" Target="../customXml/item1.xml"/><Relationship Id="rId6" Type="http://schemas.openxmlformats.org/officeDocument/2006/relationships/slideMaster" Target="slideMasters/slideMaster3.xml"/><Relationship Id="rId11" Type="http://schemas.openxmlformats.org/officeDocument/2006/relationships/slide" Target="slides/slide1.xml"/><Relationship Id="rId24" Type="http://schemas.openxmlformats.org/officeDocument/2006/relationships/theme" Target="theme/theme1.xml"/><Relationship Id="rId5" Type="http://schemas.openxmlformats.org/officeDocument/2006/relationships/slideMaster" Target="slideMasters/slideMaster2.xml"/><Relationship Id="rId15" Type="http://schemas.openxmlformats.org/officeDocument/2006/relationships/slide" Target="slides/slide5.xml"/><Relationship Id="rId23" Type="http://schemas.openxmlformats.org/officeDocument/2006/relationships/viewProps" Target="viewProps.xml"/><Relationship Id="rId10" Type="http://schemas.openxmlformats.org/officeDocument/2006/relationships/slideMaster" Target="slideMasters/slideMaster7.xml"/><Relationship Id="rId19" Type="http://schemas.openxmlformats.org/officeDocument/2006/relationships/slide" Target="slides/slide9.xml"/><Relationship Id="rId4" Type="http://schemas.openxmlformats.org/officeDocument/2006/relationships/slideMaster" Target="slideMasters/slideMaster1.xml"/><Relationship Id="rId9" Type="http://schemas.openxmlformats.org/officeDocument/2006/relationships/slideMaster" Target="slideMasters/slideMaster6.xml"/><Relationship Id="rId14" Type="http://schemas.openxmlformats.org/officeDocument/2006/relationships/slide" Target="slides/slide4.xml"/><Relationship Id="rId22" Type="http://schemas.openxmlformats.org/officeDocument/2006/relationships/presProps" Target="presProps.xml"/><Relationship Id="rId27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eph Pena" userId="S::jopena@wakehealth.edu::50f06d06-5411-4558-842a-4760be2cf84a" providerId="AD" clId="Web-{A05F717A-C282-749B-DF8E-86A0B3BF4721}"/>
    <pc:docChg chg="modSld">
      <pc:chgData name="Joseph Pena" userId="S::jopena@wakehealth.edu::50f06d06-5411-4558-842a-4760be2cf84a" providerId="AD" clId="Web-{A05F717A-C282-749B-DF8E-86A0B3BF4721}" dt="2022-01-29T15:04:42.475" v="1" actId="20577"/>
      <pc:docMkLst>
        <pc:docMk/>
      </pc:docMkLst>
      <pc:sldChg chg="modSp">
        <pc:chgData name="Joseph Pena" userId="S::jopena@wakehealth.edu::50f06d06-5411-4558-842a-4760be2cf84a" providerId="AD" clId="Web-{A05F717A-C282-749B-DF8E-86A0B3BF4721}" dt="2022-01-29T15:04:42.475" v="1" actId="20577"/>
        <pc:sldMkLst>
          <pc:docMk/>
          <pc:sldMk cId="1244536746" sldId="261"/>
        </pc:sldMkLst>
        <pc:spChg chg="mod">
          <ac:chgData name="Joseph Pena" userId="S::jopena@wakehealth.edu::50f06d06-5411-4558-842a-4760be2cf84a" providerId="AD" clId="Web-{A05F717A-C282-749B-DF8E-86A0B3BF4721}" dt="2022-01-29T15:04:42.475" v="1" actId="20577"/>
          <ac:spMkLst>
            <pc:docMk/>
            <pc:sldMk cId="1244536746" sldId="261"/>
            <ac:spMk id="13" creationId="{D7E94C25-086C-42AD-AAD7-60E959420A9D}"/>
          </ac:spMkLst>
        </pc:spChg>
      </pc:sldChg>
    </pc:docChg>
  </pc:docChgLst>
  <pc:docChgLst>
    <pc:chgData name="Elizabeth Xiang Li Grubb" userId="S::exgrubb@wakehealth.edu::39f6dd89-1f87-4177-8214-82ebed8167f6" providerId="AD" clId="Web-{7CE36A9C-D8B9-415A-B4BE-F14AFBD29013}"/>
    <pc:docChg chg="modSld">
      <pc:chgData name="Elizabeth Xiang Li Grubb" userId="S::exgrubb@wakehealth.edu::39f6dd89-1f87-4177-8214-82ebed8167f6" providerId="AD" clId="Web-{7CE36A9C-D8B9-415A-B4BE-F14AFBD29013}" dt="2022-01-29T14:59:59.498" v="311" actId="20577"/>
      <pc:docMkLst>
        <pc:docMk/>
      </pc:docMkLst>
      <pc:sldChg chg="addSp delSp modSp">
        <pc:chgData name="Elizabeth Xiang Li Grubb" userId="S::exgrubb@wakehealth.edu::39f6dd89-1f87-4177-8214-82ebed8167f6" providerId="AD" clId="Web-{7CE36A9C-D8B9-415A-B4BE-F14AFBD29013}" dt="2022-01-29T14:46:19.074" v="46" actId="20577"/>
        <pc:sldMkLst>
          <pc:docMk/>
          <pc:sldMk cId="1244536746" sldId="261"/>
        </pc:sldMkLst>
        <pc:spChg chg="add mod">
          <ac:chgData name="Elizabeth Xiang Li Grubb" userId="S::exgrubb@wakehealth.edu::39f6dd89-1f87-4177-8214-82ebed8167f6" providerId="AD" clId="Web-{7CE36A9C-D8B9-415A-B4BE-F14AFBD29013}" dt="2022-01-29T14:46:19.074" v="46" actId="20577"/>
          <ac:spMkLst>
            <pc:docMk/>
            <pc:sldMk cId="1244536746" sldId="261"/>
            <ac:spMk id="13" creationId="{D7E94C25-086C-42AD-AAD7-60E959420A9D}"/>
          </ac:spMkLst>
        </pc:spChg>
        <pc:grpChg chg="del">
          <ac:chgData name="Elizabeth Xiang Li Grubb" userId="S::exgrubb@wakehealth.edu::39f6dd89-1f87-4177-8214-82ebed8167f6" providerId="AD" clId="Web-{7CE36A9C-D8B9-415A-B4BE-F14AFBD29013}" dt="2022-01-29T14:45:02.870" v="0"/>
          <ac:grpSpMkLst>
            <pc:docMk/>
            <pc:sldMk cId="1244536746" sldId="261"/>
            <ac:grpSpMk id="3" creationId="{00000000-0000-0000-0000-000000000000}"/>
          </ac:grpSpMkLst>
        </pc:grpChg>
        <pc:picChg chg="add mod">
          <ac:chgData name="Elizabeth Xiang Li Grubb" userId="S::exgrubb@wakehealth.edu::39f6dd89-1f87-4177-8214-82ebed8167f6" providerId="AD" clId="Web-{7CE36A9C-D8B9-415A-B4BE-F14AFBD29013}" dt="2022-01-29T14:45:20.104" v="5" actId="1076"/>
          <ac:picMkLst>
            <pc:docMk/>
            <pc:sldMk cId="1244536746" sldId="261"/>
            <ac:picMk id="2" creationId="{46A38785-F1EC-42FE-9609-621ED4364046}"/>
          </ac:picMkLst>
        </pc:picChg>
        <pc:cxnChg chg="del">
          <ac:chgData name="Elizabeth Xiang Li Grubb" userId="S::exgrubb@wakehealth.edu::39f6dd89-1f87-4177-8214-82ebed8167f6" providerId="AD" clId="Web-{7CE36A9C-D8B9-415A-B4BE-F14AFBD29013}" dt="2022-01-29T14:45:05.135" v="1"/>
          <ac:cxnSpMkLst>
            <pc:docMk/>
            <pc:sldMk cId="1244536746" sldId="261"/>
            <ac:cxnSpMk id="16" creationId="{00000000-0000-0000-0000-000000000000}"/>
          </ac:cxnSpMkLst>
        </pc:cxnChg>
      </pc:sldChg>
      <pc:sldChg chg="addSp modSp">
        <pc:chgData name="Elizabeth Xiang Li Grubb" userId="S::exgrubb@wakehealth.edu::39f6dd89-1f87-4177-8214-82ebed8167f6" providerId="AD" clId="Web-{7CE36A9C-D8B9-415A-B4BE-F14AFBD29013}" dt="2022-01-29T14:47:15.591" v="70" actId="20577"/>
        <pc:sldMkLst>
          <pc:docMk/>
          <pc:sldMk cId="2801089613" sldId="262"/>
        </pc:sldMkLst>
        <pc:spChg chg="add mod">
          <ac:chgData name="Elizabeth Xiang Li Grubb" userId="S::exgrubb@wakehealth.edu::39f6dd89-1f87-4177-8214-82ebed8167f6" providerId="AD" clId="Web-{7CE36A9C-D8B9-415A-B4BE-F14AFBD29013}" dt="2022-01-29T14:47:15.591" v="70" actId="20577"/>
          <ac:spMkLst>
            <pc:docMk/>
            <pc:sldMk cId="2801089613" sldId="262"/>
            <ac:spMk id="2" creationId="{6CC1FFF0-E292-483B-8F17-8980E2A38BF7}"/>
          </ac:spMkLst>
        </pc:spChg>
      </pc:sldChg>
      <pc:sldChg chg="addSp delSp modSp modNotes">
        <pc:chgData name="Elizabeth Xiang Li Grubb" userId="S::exgrubb@wakehealth.edu::39f6dd89-1f87-4177-8214-82ebed8167f6" providerId="AD" clId="Web-{7CE36A9C-D8B9-415A-B4BE-F14AFBD29013}" dt="2022-01-29T14:51:57.082" v="125" actId="20577"/>
        <pc:sldMkLst>
          <pc:docMk/>
          <pc:sldMk cId="1674028625" sldId="263"/>
        </pc:sldMkLst>
        <pc:spChg chg="add del mod">
          <ac:chgData name="Elizabeth Xiang Li Grubb" userId="S::exgrubb@wakehealth.edu::39f6dd89-1f87-4177-8214-82ebed8167f6" providerId="AD" clId="Web-{7CE36A9C-D8B9-415A-B4BE-F14AFBD29013}" dt="2022-01-29T14:47:53.498" v="77"/>
          <ac:spMkLst>
            <pc:docMk/>
            <pc:sldMk cId="1674028625" sldId="263"/>
            <ac:spMk id="2" creationId="{59B1DCFC-DB59-4127-8D4D-D76FC20E5FC9}"/>
          </ac:spMkLst>
        </pc:spChg>
        <pc:spChg chg="topLvl">
          <ac:chgData name="Elizabeth Xiang Li Grubb" userId="S::exgrubb@wakehealth.edu::39f6dd89-1f87-4177-8214-82ebed8167f6" providerId="AD" clId="Web-{7CE36A9C-D8B9-415A-B4BE-F14AFBD29013}" dt="2022-01-29T14:48:17.671" v="78"/>
          <ac:spMkLst>
            <pc:docMk/>
            <pc:sldMk cId="1674028625" sldId="263"/>
            <ac:spMk id="5" creationId="{39884D49-BC3C-4F2F-9B0C-92C9B97C1BFF}"/>
          </ac:spMkLst>
        </pc:spChg>
        <pc:spChg chg="add del">
          <ac:chgData name="Elizabeth Xiang Li Grubb" userId="S::exgrubb@wakehealth.edu::39f6dd89-1f87-4177-8214-82ebed8167f6" providerId="AD" clId="Web-{7CE36A9C-D8B9-415A-B4BE-F14AFBD29013}" dt="2022-01-29T14:49:35.313" v="86"/>
          <ac:spMkLst>
            <pc:docMk/>
            <pc:sldMk cId="1674028625" sldId="263"/>
            <ac:spMk id="11" creationId="{A560F5EE-5E6A-422F-A8F6-1AFC0F5C84B4}"/>
          </ac:spMkLst>
        </pc:spChg>
        <pc:spChg chg="add mod">
          <ac:chgData name="Elizabeth Xiang Li Grubb" userId="S::exgrubb@wakehealth.edu::39f6dd89-1f87-4177-8214-82ebed8167f6" providerId="AD" clId="Web-{7CE36A9C-D8B9-415A-B4BE-F14AFBD29013}" dt="2022-01-29T14:51:57.082" v="125" actId="20577"/>
          <ac:spMkLst>
            <pc:docMk/>
            <pc:sldMk cId="1674028625" sldId="263"/>
            <ac:spMk id="12" creationId="{B57B2748-5C8E-4FFA-B2C7-010B6A607695}"/>
          </ac:spMkLst>
        </pc:spChg>
        <pc:grpChg chg="del">
          <ac:chgData name="Elizabeth Xiang Li Grubb" userId="S::exgrubb@wakehealth.edu::39f6dd89-1f87-4177-8214-82ebed8167f6" providerId="AD" clId="Web-{7CE36A9C-D8B9-415A-B4BE-F14AFBD29013}" dt="2022-01-29T14:48:17.671" v="78"/>
          <ac:grpSpMkLst>
            <pc:docMk/>
            <pc:sldMk cId="1674028625" sldId="263"/>
            <ac:grpSpMk id="3" creationId="{00000000-0000-0000-0000-000000000000}"/>
          </ac:grpSpMkLst>
        </pc:grpChg>
        <pc:grpChg chg="add mod">
          <ac:chgData name="Elizabeth Xiang Li Grubb" userId="S::exgrubb@wakehealth.edu::39f6dd89-1f87-4177-8214-82ebed8167f6" providerId="AD" clId="Web-{7CE36A9C-D8B9-415A-B4BE-F14AFBD29013}" dt="2022-01-29T14:50:03.532" v="87" actId="1076"/>
          <ac:grpSpMkLst>
            <pc:docMk/>
            <pc:sldMk cId="1674028625" sldId="263"/>
            <ac:grpSpMk id="10" creationId="{1CC816EA-190F-4849-B12B-E5C7697E9FCE}"/>
          </ac:grpSpMkLst>
        </pc:grpChg>
        <pc:picChg chg="topLvl">
          <ac:chgData name="Elizabeth Xiang Li Grubb" userId="S::exgrubb@wakehealth.edu::39f6dd89-1f87-4177-8214-82ebed8167f6" providerId="AD" clId="Web-{7CE36A9C-D8B9-415A-B4BE-F14AFBD29013}" dt="2022-01-29T14:48:17.671" v="78"/>
          <ac:picMkLst>
            <pc:docMk/>
            <pc:sldMk cId="1674028625" sldId="263"/>
            <ac:picMk id="4" creationId="{A364FB47-7665-4F57-81AE-AD9A77567363}"/>
          </ac:picMkLst>
        </pc:picChg>
        <pc:picChg chg="topLvl">
          <ac:chgData name="Elizabeth Xiang Li Grubb" userId="S::exgrubb@wakehealth.edu::39f6dd89-1f87-4177-8214-82ebed8167f6" providerId="AD" clId="Web-{7CE36A9C-D8B9-415A-B4BE-F14AFBD29013}" dt="2022-01-29T14:48:17.671" v="78"/>
          <ac:picMkLst>
            <pc:docMk/>
            <pc:sldMk cId="1674028625" sldId="263"/>
            <ac:picMk id="6" creationId="{E374822A-926B-46F1-BC5F-8E5F2AB52C1B}"/>
          </ac:picMkLst>
        </pc:picChg>
        <pc:cxnChg chg="topLvl">
          <ac:chgData name="Elizabeth Xiang Li Grubb" userId="S::exgrubb@wakehealth.edu::39f6dd89-1f87-4177-8214-82ebed8167f6" providerId="AD" clId="Web-{7CE36A9C-D8B9-415A-B4BE-F14AFBD29013}" dt="2022-01-29T14:48:17.671" v="78"/>
          <ac:cxnSpMkLst>
            <pc:docMk/>
            <pc:sldMk cId="1674028625" sldId="263"/>
            <ac:cxnSpMk id="7" creationId="{AEB2DB0D-A458-4300-9979-F8E057C67BEA}"/>
          </ac:cxnSpMkLst>
        </pc:cxnChg>
        <pc:cxnChg chg="topLvl">
          <ac:chgData name="Elizabeth Xiang Li Grubb" userId="S::exgrubb@wakehealth.edu::39f6dd89-1f87-4177-8214-82ebed8167f6" providerId="AD" clId="Web-{7CE36A9C-D8B9-415A-B4BE-F14AFBD29013}" dt="2022-01-29T14:48:17.671" v="78"/>
          <ac:cxnSpMkLst>
            <pc:docMk/>
            <pc:sldMk cId="1674028625" sldId="263"/>
            <ac:cxnSpMk id="8" creationId="{700EB373-491A-46B7-BE78-655CBC8DA2FA}"/>
          </ac:cxnSpMkLst>
        </pc:cxnChg>
        <pc:cxnChg chg="topLvl">
          <ac:chgData name="Elizabeth Xiang Li Grubb" userId="S::exgrubb@wakehealth.edu::39f6dd89-1f87-4177-8214-82ebed8167f6" providerId="AD" clId="Web-{7CE36A9C-D8B9-415A-B4BE-F14AFBD29013}" dt="2022-01-29T14:48:17.671" v="78"/>
          <ac:cxnSpMkLst>
            <pc:docMk/>
            <pc:sldMk cId="1674028625" sldId="263"/>
            <ac:cxnSpMk id="9" creationId="{E6D9890F-5367-4EF0-AB21-698C0046116E}"/>
          </ac:cxnSpMkLst>
        </pc:cxnChg>
      </pc:sldChg>
      <pc:sldChg chg="addSp modSp">
        <pc:chgData name="Elizabeth Xiang Li Grubb" userId="S::exgrubb@wakehealth.edu::39f6dd89-1f87-4177-8214-82ebed8167f6" providerId="AD" clId="Web-{7CE36A9C-D8B9-415A-B4BE-F14AFBD29013}" dt="2022-01-29T14:52:58.645" v="158" actId="20577"/>
        <pc:sldMkLst>
          <pc:docMk/>
          <pc:sldMk cId="4026568262" sldId="264"/>
        </pc:sldMkLst>
        <pc:spChg chg="add mod">
          <ac:chgData name="Elizabeth Xiang Li Grubb" userId="S::exgrubb@wakehealth.edu::39f6dd89-1f87-4177-8214-82ebed8167f6" providerId="AD" clId="Web-{7CE36A9C-D8B9-415A-B4BE-F14AFBD29013}" dt="2022-01-29T14:52:58.645" v="158" actId="20577"/>
          <ac:spMkLst>
            <pc:docMk/>
            <pc:sldMk cId="4026568262" sldId="264"/>
            <ac:spMk id="2" creationId="{39B5CF9B-1CA7-4C41-9B2C-E843D0545E70}"/>
          </ac:spMkLst>
        </pc:spChg>
        <pc:grpChg chg="mod">
          <ac:chgData name="Elizabeth Xiang Li Grubb" userId="S::exgrubb@wakehealth.edu::39f6dd89-1f87-4177-8214-82ebed8167f6" providerId="AD" clId="Web-{7CE36A9C-D8B9-415A-B4BE-F14AFBD29013}" dt="2022-01-29T14:52:11.316" v="128" actId="1076"/>
          <ac:grpSpMkLst>
            <pc:docMk/>
            <pc:sldMk cId="4026568262" sldId="264"/>
            <ac:grpSpMk id="3" creationId="{00000000-0000-0000-0000-000000000000}"/>
          </ac:grpSpMkLst>
        </pc:grpChg>
        <pc:grpChg chg="mod">
          <ac:chgData name="Elizabeth Xiang Li Grubb" userId="S::exgrubb@wakehealth.edu::39f6dd89-1f87-4177-8214-82ebed8167f6" providerId="AD" clId="Web-{7CE36A9C-D8B9-415A-B4BE-F14AFBD29013}" dt="2022-01-29T14:52:26.457" v="132" actId="1076"/>
          <ac:grpSpMkLst>
            <pc:docMk/>
            <pc:sldMk cId="4026568262" sldId="264"/>
            <ac:grpSpMk id="6" creationId="{00000000-0000-0000-0000-000000000000}"/>
          </ac:grpSpMkLst>
        </pc:grpChg>
      </pc:sldChg>
      <pc:sldChg chg="addSp delSp modSp">
        <pc:chgData name="Elizabeth Xiang Li Grubb" userId="S::exgrubb@wakehealth.edu::39f6dd89-1f87-4177-8214-82ebed8167f6" providerId="AD" clId="Web-{7CE36A9C-D8B9-415A-B4BE-F14AFBD29013}" dt="2022-01-29T14:57:38.216" v="241" actId="20577"/>
        <pc:sldMkLst>
          <pc:docMk/>
          <pc:sldMk cId="1276656452" sldId="265"/>
        </pc:sldMkLst>
        <pc:spChg chg="add mod">
          <ac:chgData name="Elizabeth Xiang Li Grubb" userId="S::exgrubb@wakehealth.edu::39f6dd89-1f87-4177-8214-82ebed8167f6" providerId="AD" clId="Web-{7CE36A9C-D8B9-415A-B4BE-F14AFBD29013}" dt="2022-01-29T14:57:38.216" v="241" actId="20577"/>
          <ac:spMkLst>
            <pc:docMk/>
            <pc:sldMk cId="1276656452" sldId="265"/>
            <ac:spMk id="8" creationId="{84589B19-DE62-4673-9EC3-05F093481156}"/>
          </ac:spMkLst>
        </pc:spChg>
        <pc:grpChg chg="add del mod">
          <ac:chgData name="Elizabeth Xiang Li Grubb" userId="S::exgrubb@wakehealth.edu::39f6dd89-1f87-4177-8214-82ebed8167f6" providerId="AD" clId="Web-{7CE36A9C-D8B9-415A-B4BE-F14AFBD29013}" dt="2022-01-29T14:55:03.148" v="177"/>
          <ac:grpSpMkLst>
            <pc:docMk/>
            <pc:sldMk cId="1276656452" sldId="265"/>
            <ac:grpSpMk id="2" creationId="{70274466-3D1B-4701-99A3-7A3CF7AE7D2A}"/>
          </ac:grpSpMkLst>
        </pc:grpChg>
        <pc:grpChg chg="add mod">
          <ac:chgData name="Elizabeth Xiang Li Grubb" userId="S::exgrubb@wakehealth.edu::39f6dd89-1f87-4177-8214-82ebed8167f6" providerId="AD" clId="Web-{7CE36A9C-D8B9-415A-B4BE-F14AFBD29013}" dt="2022-01-29T14:56:23.181" v="188" actId="1076"/>
          <ac:grpSpMkLst>
            <pc:docMk/>
            <pc:sldMk cId="1276656452" sldId="265"/>
            <ac:grpSpMk id="4" creationId="{1334BEC2-5FD2-43CE-9476-C224CBE228D5}"/>
          </ac:grpSpMkLst>
        </pc:grpChg>
        <pc:grpChg chg="add mod">
          <ac:chgData name="Elizabeth Xiang Li Grubb" userId="S::exgrubb@wakehealth.edu::39f6dd89-1f87-4177-8214-82ebed8167f6" providerId="AD" clId="Web-{7CE36A9C-D8B9-415A-B4BE-F14AFBD29013}" dt="2022-01-29T14:56:52.213" v="195" actId="1076"/>
          <ac:grpSpMkLst>
            <pc:docMk/>
            <pc:sldMk cId="1276656452" sldId="265"/>
            <ac:grpSpMk id="7" creationId="{B6C9A45C-E0CB-43E1-8B1B-7E42D06A82D7}"/>
          </ac:grpSpMkLst>
        </pc:grpChg>
        <pc:grpChg chg="del mod">
          <ac:chgData name="Elizabeth Xiang Li Grubb" userId="S::exgrubb@wakehealth.edu::39f6dd89-1f87-4177-8214-82ebed8167f6" providerId="AD" clId="Web-{7CE36A9C-D8B9-415A-B4BE-F14AFBD29013}" dt="2022-01-29T14:55:33.446" v="183"/>
          <ac:grpSpMkLst>
            <pc:docMk/>
            <pc:sldMk cId="1276656452" sldId="265"/>
            <ac:grpSpMk id="10" creationId="{00000000-0000-0000-0000-000000000000}"/>
          </ac:grpSpMkLst>
        </pc:grpChg>
        <pc:picChg chg="mod topLvl">
          <ac:chgData name="Elizabeth Xiang Li Grubb" userId="S::exgrubb@wakehealth.edu::39f6dd89-1f87-4177-8214-82ebed8167f6" providerId="AD" clId="Web-{7CE36A9C-D8B9-415A-B4BE-F14AFBD29013}" dt="2022-01-29T14:56:27.634" v="190" actId="14100"/>
          <ac:picMkLst>
            <pc:docMk/>
            <pc:sldMk cId="1276656452" sldId="265"/>
            <ac:picMk id="3" creationId="{00000000-0000-0000-0000-000000000000}"/>
          </ac:picMkLst>
        </pc:picChg>
        <pc:picChg chg="mod topLvl">
          <ac:chgData name="Elizabeth Xiang Li Grubb" userId="S::exgrubb@wakehealth.edu::39f6dd89-1f87-4177-8214-82ebed8167f6" providerId="AD" clId="Web-{7CE36A9C-D8B9-415A-B4BE-F14AFBD29013}" dt="2022-01-29T14:56:07.290" v="186" actId="14100"/>
          <ac:picMkLst>
            <pc:docMk/>
            <pc:sldMk cId="1276656452" sldId="265"/>
            <ac:picMk id="5" creationId="{00000000-0000-0000-0000-000000000000}"/>
          </ac:picMkLst>
        </pc:picChg>
        <pc:cxnChg chg="topLvl">
          <ac:chgData name="Elizabeth Xiang Li Grubb" userId="S::exgrubb@wakehealth.edu::39f6dd89-1f87-4177-8214-82ebed8167f6" providerId="AD" clId="Web-{7CE36A9C-D8B9-415A-B4BE-F14AFBD29013}" dt="2022-01-29T14:55:33.446" v="183"/>
          <ac:cxnSpMkLst>
            <pc:docMk/>
            <pc:sldMk cId="1276656452" sldId="265"/>
            <ac:cxnSpMk id="6" creationId="{00000000-0000-0000-0000-000000000000}"/>
          </ac:cxnSpMkLst>
        </pc:cxnChg>
        <pc:cxnChg chg="topLvl">
          <ac:chgData name="Elizabeth Xiang Li Grubb" userId="S::exgrubb@wakehealth.edu::39f6dd89-1f87-4177-8214-82ebed8167f6" providerId="AD" clId="Web-{7CE36A9C-D8B9-415A-B4BE-F14AFBD29013}" dt="2022-01-29T14:55:03.148" v="177"/>
          <ac:cxnSpMkLst>
            <pc:docMk/>
            <pc:sldMk cId="1276656452" sldId="265"/>
            <ac:cxnSpMk id="9" creationId="{00000000-0000-0000-0000-000000000000}"/>
          </ac:cxnSpMkLst>
        </pc:cxnChg>
      </pc:sldChg>
      <pc:sldChg chg="addSp modSp">
        <pc:chgData name="Elizabeth Xiang Li Grubb" userId="S::exgrubb@wakehealth.edu::39f6dd89-1f87-4177-8214-82ebed8167f6" providerId="AD" clId="Web-{7CE36A9C-D8B9-415A-B4BE-F14AFBD29013}" dt="2022-01-29T14:59:12.685" v="275" actId="1076"/>
        <pc:sldMkLst>
          <pc:docMk/>
          <pc:sldMk cId="2401425955" sldId="266"/>
        </pc:sldMkLst>
        <pc:spChg chg="add mod">
          <ac:chgData name="Elizabeth Xiang Li Grubb" userId="S::exgrubb@wakehealth.edu::39f6dd89-1f87-4177-8214-82ebed8167f6" providerId="AD" clId="Web-{7CE36A9C-D8B9-415A-B4BE-F14AFBD29013}" dt="2022-01-29T14:59:12.685" v="275" actId="1076"/>
          <ac:spMkLst>
            <pc:docMk/>
            <pc:sldMk cId="2401425955" sldId="266"/>
            <ac:spMk id="3" creationId="{3F11CC29-7C70-48DF-AE43-929623253D36}"/>
          </ac:spMkLst>
        </pc:spChg>
      </pc:sldChg>
      <pc:sldChg chg="addSp modSp">
        <pc:chgData name="Elizabeth Xiang Li Grubb" userId="S::exgrubb@wakehealth.edu::39f6dd89-1f87-4177-8214-82ebed8167f6" providerId="AD" clId="Web-{7CE36A9C-D8B9-415A-B4BE-F14AFBD29013}" dt="2022-01-29T14:59:59.498" v="311" actId="20577"/>
        <pc:sldMkLst>
          <pc:docMk/>
          <pc:sldMk cId="3134022891" sldId="267"/>
        </pc:sldMkLst>
        <pc:spChg chg="add mod">
          <ac:chgData name="Elizabeth Xiang Li Grubb" userId="S::exgrubb@wakehealth.edu::39f6dd89-1f87-4177-8214-82ebed8167f6" providerId="AD" clId="Web-{7CE36A9C-D8B9-415A-B4BE-F14AFBD29013}" dt="2022-01-29T14:59:59.498" v="311" actId="20577"/>
          <ac:spMkLst>
            <pc:docMk/>
            <pc:sldMk cId="3134022891" sldId="267"/>
            <ac:spMk id="2" creationId="{41ABA8E4-2CEB-43E1-B831-B1AF34431044}"/>
          </ac:spMkLst>
        </pc:spChg>
      </pc:sldChg>
    </pc:docChg>
  </pc:docChgLst>
  <pc:docChgLst>
    <pc:chgData name="Chris Lack" userId="b505786b-2a1c-4109-9146-25ee79070910" providerId="ADAL" clId="{4A0F8A8D-1678-4F2C-ABCC-C272920BD3F7}"/>
    <pc:docChg chg="undo custSel modSld">
      <pc:chgData name="Chris Lack" userId="b505786b-2a1c-4109-9146-25ee79070910" providerId="ADAL" clId="{4A0F8A8D-1678-4F2C-ABCC-C272920BD3F7}" dt="2022-02-03T21:35:40.118" v="125" actId="2"/>
      <pc:docMkLst>
        <pc:docMk/>
      </pc:docMkLst>
      <pc:sldChg chg="modNotesTx">
        <pc:chgData name="Chris Lack" userId="b505786b-2a1c-4109-9146-25ee79070910" providerId="ADAL" clId="{4A0F8A8D-1678-4F2C-ABCC-C272920BD3F7}" dt="2022-02-03T21:28:05.010" v="17" actId="20577"/>
        <pc:sldMkLst>
          <pc:docMk/>
          <pc:sldMk cId="1626584310" sldId="258"/>
        </pc:sldMkLst>
      </pc:sldChg>
      <pc:sldChg chg="modNotesTx">
        <pc:chgData name="Chris Lack" userId="b505786b-2a1c-4109-9146-25ee79070910" providerId="ADAL" clId="{4A0F8A8D-1678-4F2C-ABCC-C272920BD3F7}" dt="2022-02-03T21:29:09.187" v="31" actId="20577"/>
        <pc:sldMkLst>
          <pc:docMk/>
          <pc:sldMk cId="3126080735" sldId="259"/>
        </pc:sldMkLst>
      </pc:sldChg>
      <pc:sldChg chg="modNotesTx">
        <pc:chgData name="Chris Lack" userId="b505786b-2a1c-4109-9146-25ee79070910" providerId="ADAL" clId="{4A0F8A8D-1678-4F2C-ABCC-C272920BD3F7}" dt="2022-02-03T21:30:34.338" v="37" actId="20577"/>
        <pc:sldMkLst>
          <pc:docMk/>
          <pc:sldMk cId="4014164531" sldId="260"/>
        </pc:sldMkLst>
      </pc:sldChg>
      <pc:sldChg chg="modNotesTx">
        <pc:chgData name="Chris Lack" userId="b505786b-2a1c-4109-9146-25ee79070910" providerId="ADAL" clId="{4A0F8A8D-1678-4F2C-ABCC-C272920BD3F7}" dt="2022-02-03T21:30:49.906" v="44" actId="20577"/>
        <pc:sldMkLst>
          <pc:docMk/>
          <pc:sldMk cId="1244536746" sldId="261"/>
        </pc:sldMkLst>
      </pc:sldChg>
      <pc:sldChg chg="modSp mod modNotesTx">
        <pc:chgData name="Chris Lack" userId="b505786b-2a1c-4109-9146-25ee79070910" providerId="ADAL" clId="{4A0F8A8D-1678-4F2C-ABCC-C272920BD3F7}" dt="2022-02-03T21:34:19.345" v="121" actId="20577"/>
        <pc:sldMkLst>
          <pc:docMk/>
          <pc:sldMk cId="2801089613" sldId="262"/>
        </pc:sldMkLst>
        <pc:spChg chg="mod">
          <ac:chgData name="Chris Lack" userId="b505786b-2a1c-4109-9146-25ee79070910" providerId="ADAL" clId="{4A0F8A8D-1678-4F2C-ABCC-C272920BD3F7}" dt="2022-02-03T21:31:18.650" v="49" actId="20577"/>
          <ac:spMkLst>
            <pc:docMk/>
            <pc:sldMk cId="2801089613" sldId="262"/>
            <ac:spMk id="2" creationId="{6CC1FFF0-E292-483B-8F17-8980E2A38BF7}"/>
          </ac:spMkLst>
        </pc:spChg>
      </pc:sldChg>
      <pc:sldChg chg="modSp mod modNotesTx">
        <pc:chgData name="Chris Lack" userId="b505786b-2a1c-4109-9146-25ee79070910" providerId="ADAL" clId="{4A0F8A8D-1678-4F2C-ABCC-C272920BD3F7}" dt="2022-02-03T21:35:40.118" v="125" actId="2"/>
        <pc:sldMkLst>
          <pc:docMk/>
          <pc:sldMk cId="1674028625" sldId="263"/>
        </pc:sldMkLst>
        <pc:spChg chg="mod">
          <ac:chgData name="Chris Lack" userId="b505786b-2a1c-4109-9146-25ee79070910" providerId="ADAL" clId="{4A0F8A8D-1678-4F2C-ABCC-C272920BD3F7}" dt="2022-02-03T21:35:40.118" v="125" actId="2"/>
          <ac:spMkLst>
            <pc:docMk/>
            <pc:sldMk cId="1674028625" sldId="263"/>
            <ac:spMk id="12" creationId="{B57B2748-5C8E-4FFA-B2C7-010B6A607695}"/>
          </ac:spMkLst>
        </pc:spChg>
      </pc:sldChg>
      <pc:sldChg chg="modNotesTx">
        <pc:chgData name="Chris Lack" userId="b505786b-2a1c-4109-9146-25ee79070910" providerId="ADAL" clId="{4A0F8A8D-1678-4F2C-ABCC-C272920BD3F7}" dt="2022-02-03T21:32:37.169" v="61" actId="20577"/>
        <pc:sldMkLst>
          <pc:docMk/>
          <pc:sldMk cId="4026568262" sldId="264"/>
        </pc:sldMkLst>
      </pc:sldChg>
      <pc:sldChg chg="modNotesTx">
        <pc:chgData name="Chris Lack" userId="b505786b-2a1c-4109-9146-25ee79070910" providerId="ADAL" clId="{4A0F8A8D-1678-4F2C-ABCC-C272920BD3F7}" dt="2022-02-03T21:32:53.488" v="67" actId="20577"/>
        <pc:sldMkLst>
          <pc:docMk/>
          <pc:sldMk cId="1276656452" sldId="265"/>
        </pc:sldMkLst>
      </pc:sldChg>
      <pc:sldChg chg="modSp mod modNotesTx">
        <pc:chgData name="Chris Lack" userId="b505786b-2a1c-4109-9146-25ee79070910" providerId="ADAL" clId="{4A0F8A8D-1678-4F2C-ABCC-C272920BD3F7}" dt="2022-02-03T21:34:31.633" v="124" actId="20577"/>
        <pc:sldMkLst>
          <pc:docMk/>
          <pc:sldMk cId="2401425955" sldId="266"/>
        </pc:sldMkLst>
        <pc:spChg chg="mod">
          <ac:chgData name="Chris Lack" userId="b505786b-2a1c-4109-9146-25ee79070910" providerId="ADAL" clId="{4A0F8A8D-1678-4F2C-ABCC-C272920BD3F7}" dt="2022-02-03T21:33:15.782" v="76" actId="313"/>
          <ac:spMkLst>
            <pc:docMk/>
            <pc:sldMk cId="2401425955" sldId="266"/>
            <ac:spMk id="3" creationId="{3F11CC29-7C70-48DF-AE43-929623253D36}"/>
          </ac:spMkLst>
        </pc:spChg>
      </pc:sldChg>
      <pc:sldChg chg="modNotesTx">
        <pc:chgData name="Chris Lack" userId="b505786b-2a1c-4109-9146-25ee79070910" providerId="ADAL" clId="{4A0F8A8D-1678-4F2C-ABCC-C272920BD3F7}" dt="2022-02-03T21:34:10.129" v="119" actId="20577"/>
        <pc:sldMkLst>
          <pc:docMk/>
          <pc:sldMk cId="3134022891" sldId="267"/>
        </pc:sldMkLst>
      </pc:sldChg>
    </pc:docChg>
  </pc:docChgLst>
  <pc:docChgLst>
    <pc:chgData name="Elizabeth Xiang Li Grubb" userId="S::exgrubb@wakehealth.edu::39f6dd89-1f87-4177-8214-82ebed8167f6" providerId="AD" clId="Web-{8AA2727A-324A-4D5B-8DC1-28A67AB19640}"/>
    <pc:docChg chg="modSld">
      <pc:chgData name="Elizabeth Xiang Li Grubb" userId="S::exgrubb@wakehealth.edu::39f6dd89-1f87-4177-8214-82ebed8167f6" providerId="AD" clId="Web-{8AA2727A-324A-4D5B-8DC1-28A67AB19640}" dt="2022-01-29T14:35:46.931" v="60" actId="1076"/>
      <pc:docMkLst>
        <pc:docMk/>
      </pc:docMkLst>
      <pc:sldChg chg="addSp modSp">
        <pc:chgData name="Elizabeth Xiang Li Grubb" userId="S::exgrubb@wakehealth.edu::39f6dd89-1f87-4177-8214-82ebed8167f6" providerId="AD" clId="Web-{8AA2727A-324A-4D5B-8DC1-28A67AB19640}" dt="2022-01-29T14:35:46.931" v="60" actId="1076"/>
        <pc:sldMkLst>
          <pc:docMk/>
          <pc:sldMk cId="1626584310" sldId="258"/>
        </pc:sldMkLst>
        <pc:spChg chg="add mod">
          <ac:chgData name="Elizabeth Xiang Li Grubb" userId="S::exgrubb@wakehealth.edu::39f6dd89-1f87-4177-8214-82ebed8167f6" providerId="AD" clId="Web-{8AA2727A-324A-4D5B-8DC1-28A67AB19640}" dt="2022-01-29T14:35:46.931" v="60" actId="1076"/>
          <ac:spMkLst>
            <pc:docMk/>
            <pc:sldMk cId="1626584310" sldId="258"/>
            <ac:spMk id="2" creationId="{2A5ADD03-88EA-44A7-8CDA-0F898D15A84F}"/>
          </ac:spMkLst>
        </pc:spChg>
        <pc:picChg chg="mod">
          <ac:chgData name="Elizabeth Xiang Li Grubb" userId="S::exgrubb@wakehealth.edu::39f6dd89-1f87-4177-8214-82ebed8167f6" providerId="AD" clId="Web-{8AA2727A-324A-4D5B-8DC1-28A67AB19640}" dt="2022-01-29T14:34:43.195" v="21" actId="1076"/>
          <ac:picMkLst>
            <pc:docMk/>
            <pc:sldMk cId="1626584310" sldId="258"/>
            <ac:picMk id="4" creationId="{BB70BD82-AEBF-454A-9E48-4E83B6448DB4}"/>
          </ac:picMkLst>
        </pc:picChg>
      </pc:sldChg>
      <pc:sldChg chg="addSp delSp modSp">
        <pc:chgData name="Elizabeth Xiang Li Grubb" userId="S::exgrubb@wakehealth.edu::39f6dd89-1f87-4177-8214-82ebed8167f6" providerId="AD" clId="Web-{8AA2727A-324A-4D5B-8DC1-28A67AB19640}" dt="2022-01-29T14:34:04.038" v="19" actId="14100"/>
        <pc:sldMkLst>
          <pc:docMk/>
          <pc:sldMk cId="2401425955" sldId="266"/>
        </pc:sldMkLst>
        <pc:spChg chg="add">
          <ac:chgData name="Elizabeth Xiang Li Grubb" userId="S::exgrubb@wakehealth.edu::39f6dd89-1f87-4177-8214-82ebed8167f6" providerId="AD" clId="Web-{8AA2727A-324A-4D5B-8DC1-28A67AB19640}" dt="2022-01-29T14:33:05.693" v="0"/>
          <ac:spMkLst>
            <pc:docMk/>
            <pc:sldMk cId="2401425955" sldId="266"/>
            <ac:spMk id="2" creationId="{D15FCE9A-746E-41C2-87A5-669FF45D68F0}"/>
          </ac:spMkLst>
        </pc:spChg>
        <pc:spChg chg="add del mod">
          <ac:chgData name="Elizabeth Xiang Li Grubb" userId="S::exgrubb@wakehealth.edu::39f6dd89-1f87-4177-8214-82ebed8167f6" providerId="AD" clId="Web-{8AA2727A-324A-4D5B-8DC1-28A67AB19640}" dt="2022-01-29T14:33:23.006" v="4"/>
          <ac:spMkLst>
            <pc:docMk/>
            <pc:sldMk cId="2401425955" sldId="266"/>
            <ac:spMk id="3" creationId="{606F4AC5-AF57-42C3-AD5D-3C4AC64AC955}"/>
          </ac:spMkLst>
        </pc:spChg>
        <pc:spChg chg="add mod">
          <ac:chgData name="Elizabeth Xiang Li Grubb" userId="S::exgrubb@wakehealth.edu::39f6dd89-1f87-4177-8214-82ebed8167f6" providerId="AD" clId="Web-{8AA2727A-324A-4D5B-8DC1-28A67AB19640}" dt="2022-01-29T14:34:04.038" v="19" actId="14100"/>
          <ac:spMkLst>
            <pc:docMk/>
            <pc:sldMk cId="2401425955" sldId="266"/>
            <ac:spMk id="4" creationId="{E227FA05-B82C-443B-A0C7-2873C535026F}"/>
          </ac:spMkLst>
        </pc:spChg>
      </pc:sldChg>
    </pc:docChg>
  </pc:docChgLst>
  <pc:docChgLst>
    <pc:chgData name="Elizabeth Xiang Li Grubb" userId="S::exgrubb@wakehealth.edu::39f6dd89-1f87-4177-8214-82ebed8167f6" providerId="AD" clId="Web-{DD9C4CE7-F106-475A-B903-CD5863044556}"/>
    <pc:docChg chg="modSld">
      <pc:chgData name="Elizabeth Xiang Li Grubb" userId="S::exgrubb@wakehealth.edu::39f6dd89-1f87-4177-8214-82ebed8167f6" providerId="AD" clId="Web-{DD9C4CE7-F106-475A-B903-CD5863044556}" dt="2022-01-29T14:43:30.309" v="89" actId="20577"/>
      <pc:docMkLst>
        <pc:docMk/>
      </pc:docMkLst>
      <pc:sldChg chg="addSp modSp">
        <pc:chgData name="Elizabeth Xiang Li Grubb" userId="S::exgrubb@wakehealth.edu::39f6dd89-1f87-4177-8214-82ebed8167f6" providerId="AD" clId="Web-{DD9C4CE7-F106-475A-B903-CD5863044556}" dt="2022-01-29T14:39:31.561" v="51" actId="1076"/>
        <pc:sldMkLst>
          <pc:docMk/>
          <pc:sldMk cId="3126080735" sldId="259"/>
        </pc:sldMkLst>
        <pc:spChg chg="add mod">
          <ac:chgData name="Elizabeth Xiang Li Grubb" userId="S::exgrubb@wakehealth.edu::39f6dd89-1f87-4177-8214-82ebed8167f6" providerId="AD" clId="Web-{DD9C4CE7-F106-475A-B903-CD5863044556}" dt="2022-01-29T14:39:31.561" v="51" actId="1076"/>
          <ac:spMkLst>
            <pc:docMk/>
            <pc:sldMk cId="3126080735" sldId="259"/>
            <ac:spMk id="2" creationId="{76C047E6-5EF2-45F4-AF6E-51BADE4C9A8E}"/>
          </ac:spMkLst>
        </pc:spChg>
        <pc:picChg chg="mod">
          <ac:chgData name="Elizabeth Xiang Li Grubb" userId="S::exgrubb@wakehealth.edu::39f6dd89-1f87-4177-8214-82ebed8167f6" providerId="AD" clId="Web-{DD9C4CE7-F106-475A-B903-CD5863044556}" dt="2022-01-29T14:36:52.912" v="1" actId="1076"/>
          <ac:picMkLst>
            <pc:docMk/>
            <pc:sldMk cId="3126080735" sldId="259"/>
            <ac:picMk id="3" creationId="{00000000-0000-0000-0000-000000000000}"/>
          </ac:picMkLst>
        </pc:picChg>
      </pc:sldChg>
      <pc:sldChg chg="addSp delSp modSp">
        <pc:chgData name="Elizabeth Xiang Li Grubb" userId="S::exgrubb@wakehealth.edu::39f6dd89-1f87-4177-8214-82ebed8167f6" providerId="AD" clId="Web-{DD9C4CE7-F106-475A-B903-CD5863044556}" dt="2022-01-29T14:43:30.309" v="89" actId="20577"/>
        <pc:sldMkLst>
          <pc:docMk/>
          <pc:sldMk cId="4014164531" sldId="260"/>
        </pc:sldMkLst>
        <pc:spChg chg="topLvl">
          <ac:chgData name="Elizabeth Xiang Li Grubb" userId="S::exgrubb@wakehealth.edu::39f6dd89-1f87-4177-8214-82ebed8167f6" providerId="AD" clId="Web-{DD9C4CE7-F106-475A-B903-CD5863044556}" dt="2022-01-29T14:40:10.345" v="52"/>
          <ac:spMkLst>
            <pc:docMk/>
            <pc:sldMk cId="4014164531" sldId="260"/>
            <ac:spMk id="5" creationId="{00000000-0000-0000-0000-000000000000}"/>
          </ac:spMkLst>
        </pc:spChg>
        <pc:spChg chg="topLvl">
          <ac:chgData name="Elizabeth Xiang Li Grubb" userId="S::exgrubb@wakehealth.edu::39f6dd89-1f87-4177-8214-82ebed8167f6" providerId="AD" clId="Web-{DD9C4CE7-F106-475A-B903-CD5863044556}" dt="2022-01-29T14:40:10.345" v="52"/>
          <ac:spMkLst>
            <pc:docMk/>
            <pc:sldMk cId="4014164531" sldId="260"/>
            <ac:spMk id="6" creationId="{00000000-0000-0000-0000-000000000000}"/>
          </ac:spMkLst>
        </pc:spChg>
        <pc:spChg chg="add mod">
          <ac:chgData name="Elizabeth Xiang Li Grubb" userId="S::exgrubb@wakehealth.edu::39f6dd89-1f87-4177-8214-82ebed8167f6" providerId="AD" clId="Web-{DD9C4CE7-F106-475A-B903-CD5863044556}" dt="2022-01-29T14:43:30.309" v="89" actId="20577"/>
          <ac:spMkLst>
            <pc:docMk/>
            <pc:sldMk cId="4014164531" sldId="260"/>
            <ac:spMk id="7" creationId="{7E63D460-A5C0-4091-A253-8EC8C128FF20}"/>
          </ac:spMkLst>
        </pc:spChg>
        <pc:grpChg chg="add mod">
          <ac:chgData name="Elizabeth Xiang Li Grubb" userId="S::exgrubb@wakehealth.edu::39f6dd89-1f87-4177-8214-82ebed8167f6" providerId="AD" clId="Web-{DD9C4CE7-F106-475A-B903-CD5863044556}" dt="2022-01-29T14:40:42.487" v="56" actId="1076"/>
          <ac:grpSpMkLst>
            <pc:docMk/>
            <pc:sldMk cId="4014164531" sldId="260"/>
            <ac:grpSpMk id="2" creationId="{ED7BC4EC-F2A0-46A5-A1B6-4AEF5079C8C4}"/>
          </ac:grpSpMkLst>
        </pc:grpChg>
        <pc:grpChg chg="del mod">
          <ac:chgData name="Elizabeth Xiang Li Grubb" userId="S::exgrubb@wakehealth.edu::39f6dd89-1f87-4177-8214-82ebed8167f6" providerId="AD" clId="Web-{DD9C4CE7-F106-475A-B903-CD5863044556}" dt="2022-01-29T14:40:10.345" v="52"/>
          <ac:grpSpMkLst>
            <pc:docMk/>
            <pc:sldMk cId="4014164531" sldId="260"/>
            <ac:grpSpMk id="3" creationId="{00000000-0000-0000-0000-000000000000}"/>
          </ac:grpSpMkLst>
        </pc:grpChg>
        <pc:picChg chg="mod topLvl">
          <ac:chgData name="Elizabeth Xiang Li Grubb" userId="S::exgrubb@wakehealth.edu::39f6dd89-1f87-4177-8214-82ebed8167f6" providerId="AD" clId="Web-{DD9C4CE7-F106-475A-B903-CD5863044556}" dt="2022-01-29T14:40:10.345" v="52"/>
          <ac:picMkLst>
            <pc:docMk/>
            <pc:sldMk cId="4014164531" sldId="260"/>
            <ac:picMk id="4" creationId="{00000000-0000-0000-0000-00000000000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8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A2B3FC29-ADC2-4348-9BC2-E43BE82C2D87}" type="datetimeFigureOut">
              <a:rPr lang="en-US"/>
              <a:pPr>
                <a:defRPr/>
              </a:pPr>
              <a:t>2/3/2022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2C9D91DA-CAD8-48BC-B864-358C91C766EB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145919019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Q: The lesion within the paramidline dorsal pons could result in which of the following deficits?</a:t>
            </a:r>
          </a:p>
          <a:p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A: Facial paralysis, Esotropia, Vertigo, Hearing loss, A and B</a:t>
            </a:r>
          </a:p>
          <a:p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Correct Answer: 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C558EEC-BF5E-42D5-841A-B7867F7CB640}" type="slidenum">
              <a:rPr lang="en-US" smtClean="0"/>
              <a:t>1</a:t>
            </a:fld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65C42E4-E38B-4E33-A54E-4313615FF598}"/>
              </a:ext>
            </a:extLst>
          </p:cNvPr>
          <p:cNvSpPr txBox="1"/>
          <p:nvPr/>
        </p:nvSpPr>
        <p:spPr>
          <a:xfrm>
            <a:off x="0" y="0"/>
            <a:ext cx="3810000" cy="1270000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928636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Q: Overall, how confident were you in the answer to the previous questions on a scale of 1 to 5, with 1 being not confident and 5 being very confident?</a:t>
            </a:r>
          </a:p>
          <a:p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A: 1 (Not confident), 2, 3, 4, 5 (Very confident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cs typeface="Calibri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/>
              </a:rPr>
              <a:t>Correct Answer: Not applicable to this question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B1CE854-62F8-416A-946D-8141AB94A7B2}" type="slidenum">
              <a:rPr lang="en-US" smtClean="0"/>
              <a:pPr>
                <a:defRPr/>
              </a:pPr>
              <a:t>10</a:t>
            </a:fld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810000" cy="1270000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29278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Q: Which cranial nerve nucleus is associated with the facial colliculus?</a:t>
            </a:r>
          </a:p>
          <a:p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A: V, VI, VII, VIII, IX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cs typeface="Calibri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/>
              </a:rPr>
              <a:t>Correct Answer: B</a:t>
            </a:r>
          </a:p>
          <a:p>
            <a:endParaRPr lang="en-US" dirty="0">
              <a:cs typeface="Calibri"/>
            </a:endParaRP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B1CE854-62F8-416A-946D-8141AB94A7B2}" type="slidenum">
              <a:rPr lang="en-US" smtClean="0"/>
              <a:pPr>
                <a:defRPr/>
              </a:pPr>
              <a:t>2</a:t>
            </a:fld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810000" cy="1270000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71845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Q: Which cranial nerve nucleus is indicated by the blue dots?</a:t>
            </a:r>
          </a:p>
          <a:p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A: VII, VIII, IX, X, XI</a:t>
            </a:r>
          </a:p>
          <a:p>
            <a:endParaRPr lang="en-US" dirty="0">
              <a:cs typeface="Calibri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/>
              </a:rPr>
              <a:t>Correct Answer: B</a:t>
            </a: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B1CE854-62F8-416A-946D-8141AB94A7B2}" type="slidenum">
              <a:rPr lang="en-US" smtClean="0"/>
              <a:pPr>
                <a:defRPr/>
              </a:pPr>
              <a:t>3</a:t>
            </a:fld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810000" cy="1270000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87803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Q: Which cranial nerve is most likely affected by this basilar artery aneurysm?</a:t>
            </a:r>
          </a:p>
          <a:p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A: I, II, III, IV, V</a:t>
            </a:r>
          </a:p>
          <a:p>
            <a:endParaRPr lang="en-US" dirty="0">
              <a:cs typeface="Calibri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/>
              </a:rPr>
              <a:t>Correct Answer: C</a:t>
            </a: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B1CE854-62F8-416A-946D-8141AB94A7B2}" type="slidenum">
              <a:rPr lang="en-US" smtClean="0"/>
              <a:pPr>
                <a:defRPr/>
              </a:pPr>
              <a:t>4</a:t>
            </a:fld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810000" cy="1270000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149011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Q: Which cranial nerve is indicated by the arrow?</a:t>
            </a:r>
          </a:p>
          <a:p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A: Facial nerve, Cochlear nerve, Superior vestibular nerve, Inferior vestibular nerve, Glossopharyngeal nerve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cs typeface="Calibri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/>
              </a:rPr>
              <a:t>Correct Answer: B</a:t>
            </a: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B1CE854-62F8-416A-946D-8141AB94A7B2}" type="slidenum">
              <a:rPr lang="en-US" smtClean="0"/>
              <a:pPr>
                <a:defRPr/>
              </a:pPr>
              <a:t>5</a:t>
            </a:fld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810000" cy="1270000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034521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Q: Which cranial nerve does not have roots arising from the postolivary sulcus of the medulla (blue arrow)? </a:t>
            </a:r>
          </a:p>
          <a:p>
            <a:endParaRPr lang="en-US" dirty="0"/>
          </a:p>
          <a:p>
            <a:r>
              <a:rPr lang="en-US" dirty="0"/>
              <a:t>A: Glossopharyngeal, Vagus, Spinal accessory, Hypoglossal, C and D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cs typeface="Calibri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/>
              </a:rPr>
              <a:t>Correct Answer: D</a:t>
            </a: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B1CE854-62F8-416A-946D-8141AB94A7B2}" type="slidenum">
              <a:rPr lang="en-US" smtClean="0"/>
              <a:pPr>
                <a:defRPr/>
              </a:pPr>
              <a:t>6</a:t>
            </a:fld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810000" cy="1270000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84378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Q: Which nerve does not exit through the foramen indicated by the blue arrows?</a:t>
            </a:r>
          </a:p>
          <a:p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A: III, IV, V1, V2, VI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cs typeface="Calibri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/>
              </a:rPr>
              <a:t>Correct Answer: D</a:t>
            </a: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B1CE854-62F8-416A-946D-8141AB94A7B2}" type="slidenum">
              <a:rPr lang="en-US" smtClean="0"/>
              <a:pPr>
                <a:defRPr/>
              </a:pPr>
              <a:t>7</a:t>
            </a:fld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810000" cy="1270000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694066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Q: Which cranial nerve exits the foramen indicated by the yellow arrow?</a:t>
            </a:r>
          </a:p>
          <a:p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A: Glossopharyngeal nerve, Maxillary division of CN V, Mandibular division of CN V, Hypoglossal nerve, Vagus nerve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cs typeface="Calibri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/>
              </a:rPr>
              <a:t>Correct Answer: D</a:t>
            </a: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B1CE854-62F8-416A-946D-8141AB94A7B2}" type="slidenum">
              <a:rPr lang="en-US" smtClean="0"/>
              <a:pPr>
                <a:defRPr/>
              </a:pPr>
              <a:t>8</a:t>
            </a:fld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810000" cy="1270000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714230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Q: Which cranial nerve is not associated with the lateral dural wall of the cavernous sinus?</a:t>
            </a:r>
          </a:p>
          <a:p>
            <a:endParaRPr lang="en-US" dirty="0">
              <a:cs typeface="Calibri"/>
            </a:endParaRPr>
          </a:p>
          <a:p>
            <a:r>
              <a:rPr lang="en-US" dirty="0">
                <a:cs typeface="Calibri"/>
              </a:rPr>
              <a:t>A: III, IV, Ophthalmic division V, Maxillary division of V, VI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cs typeface="Calibri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cs typeface="Calibri"/>
              </a:rPr>
              <a:t>Correct Answer: E</a:t>
            </a:r>
          </a:p>
          <a:p>
            <a:endParaRPr lang="en-US" dirty="0">
              <a:cs typeface="Calibri"/>
            </a:endParaRP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C558EEC-BF5E-42D5-841A-B7867F7CB640}" type="slidenum">
              <a:rPr lang="en-US" smtClean="0"/>
              <a:t>9</a:t>
            </a:fld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3750132-E8C9-47EB-8E09-22CE42139131}"/>
              </a:ext>
            </a:extLst>
          </p:cNvPr>
          <p:cNvSpPr txBox="1"/>
          <p:nvPr/>
        </p:nvSpPr>
        <p:spPr>
          <a:xfrm>
            <a:off x="0" y="0"/>
            <a:ext cx="3810000" cy="1270000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142933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523862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1415493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56200" y="1447801"/>
            <a:ext cx="6726200" cy="232435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381939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91600" y="227013"/>
            <a:ext cx="2590800" cy="352266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184" y="227013"/>
            <a:ext cx="2848216" cy="3522662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03934905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8518335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523862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98871312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53341999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4006148"/>
            <a:ext cx="10363200" cy="40075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50020194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92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24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6238933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712568"/>
            <a:ext cx="5386917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712568"/>
            <a:ext cx="5389033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27056900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048130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24268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67606755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240129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423772177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58541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95969573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56200" y="1447801"/>
            <a:ext cx="6726200" cy="232435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79639715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91600" y="227013"/>
            <a:ext cx="2590800" cy="352266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184" y="227013"/>
            <a:ext cx="2848216" cy="3522662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813516703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1219200" y="227013"/>
            <a:ext cx="10363200" cy="9144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1219200" y="1447800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6502400" y="1447800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1219200" y="2674939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02400" y="2674939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493633956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9200" y="227013"/>
            <a:ext cx="10363200" cy="9144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1219200" y="1447801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2400" y="1447801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2780460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1219200" y="227013"/>
            <a:ext cx="103632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649779915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xAndTwoObj" preserve="1">
  <p:cSld name="Title, Text,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9200" y="227013"/>
            <a:ext cx="10363200" cy="9144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1219200" y="1447801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6502400" y="1447800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6502400" y="2674939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399973669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214133163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523862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60A623-C8F8-4260-9B31-848E6B026E7A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299749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4006148"/>
            <a:ext cx="10363200" cy="40075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4002010486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51C687-FD4D-4AA3-982C-2C2A0DC02EDE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25298727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4006148"/>
            <a:ext cx="10363200" cy="40075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5E2824-140B-44C3-9A53-9C6C5F927AB0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429488024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92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24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6D813E-835C-47FE-A440-58B57BEF11B8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763567093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712568"/>
            <a:ext cx="5386917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712568"/>
            <a:ext cx="5389033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AF4D5D-AB4B-4823-8C48-421D53936DD5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284017529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646D7A-85C6-40A7-BD42-C83AC5E3EDAD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739611820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303ADC-0605-40CB-BEAF-3C9BF3598C50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1679940560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240129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F6F71D-1F9B-4A2C-850A-5684D05FB2F6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1690697060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58541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2A8BCC-AF9F-4C5B-AC1F-D2E726942418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879744350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56200" y="1447801"/>
            <a:ext cx="6726200" cy="232435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017FB5-23F8-40EE-AF69-5F46455E668D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2421830907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91600" y="227013"/>
            <a:ext cx="2590800" cy="352266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184" y="227013"/>
            <a:ext cx="2848216" cy="3522662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6EFB05-D0C8-4F89-A313-4BCA94408DB6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620332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92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24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876490852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8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523862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1388566296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409350220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3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4006148"/>
            <a:ext cx="10363200" cy="40075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809581350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92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24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69914837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712570"/>
            <a:ext cx="5386917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7"/>
            <a:ext cx="5386917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9" y="1712570"/>
            <a:ext cx="5389033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9" y="2174877"/>
            <a:ext cx="5389033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793307396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123355287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43482311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2"/>
            <a:ext cx="6815667" cy="240129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1435103"/>
            <a:ext cx="4011084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75397071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58541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40"/>
            <a:ext cx="7315200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04183018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56201" y="1447803"/>
            <a:ext cx="6726200" cy="232435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787795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712568"/>
            <a:ext cx="5386917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712568"/>
            <a:ext cx="5389033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822800748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91600" y="227013"/>
            <a:ext cx="2590800" cy="352266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184" y="227013"/>
            <a:ext cx="2848216" cy="3522662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205248606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790924227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8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523862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3316946514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932981322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3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4006148"/>
            <a:ext cx="10363200" cy="40075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144439856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9200" y="1447802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2400" y="1447802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43250751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712570"/>
            <a:ext cx="5386917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7"/>
            <a:ext cx="5386917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9" y="1712570"/>
            <a:ext cx="5389033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9" y="2174877"/>
            <a:ext cx="5389033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227822663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189893455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251449158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2"/>
            <a:ext cx="6815667" cy="240129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1435103"/>
            <a:ext cx="4011084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330085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008408614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58541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40"/>
            <a:ext cx="7315200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4009484765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56201" y="1447803"/>
            <a:ext cx="6726200" cy="232435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85621171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91600" y="227013"/>
            <a:ext cx="2590800" cy="352266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184" y="227013"/>
            <a:ext cx="2848216" cy="3522662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394257986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1219200" y="227013"/>
            <a:ext cx="10363200" cy="9144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1219200" y="1447801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6502400" y="1447801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1219200" y="2674940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02400" y="2674940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257781478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9200" y="227013"/>
            <a:ext cx="10363200" cy="9144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1219200" y="1447802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2400" y="1447802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85433580"/>
      </p:ext>
    </p:extLst>
  </p:cSld>
  <p:clrMapOvr>
    <a:masterClrMapping/>
  </p:clrMapOvr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1219200" y="227015"/>
            <a:ext cx="103632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90081777"/>
      </p:ext>
    </p:extLst>
  </p:cSld>
  <p:clrMapOvr>
    <a:masterClrMapping/>
  </p:clrMapOvr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txAndTwoObj" preserve="1">
  <p:cSld name="Title, Text,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9200" y="227013"/>
            <a:ext cx="10363200" cy="9144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1219200" y="1447802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6502400" y="1447801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6502400" y="2674940"/>
            <a:ext cx="5080000" cy="2324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313097375"/>
      </p:ext>
    </p:extLst>
  </p:cSld>
  <p:clrMapOvr>
    <a:masterClrMapping/>
  </p:clrMapOvr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463196261"/>
      </p:ext>
    </p:extLst>
  </p:cSld>
  <p:clrMapOvr>
    <a:masterClrMapping/>
  </p:clrMapOvr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8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523862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43878E-514A-4E9C-B96D-02149CCA4C42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154204952"/>
      </p:ext>
    </p:extLst>
  </p:cSld>
  <p:clrMapOvr>
    <a:masterClrMapping/>
  </p:clrMapOvr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F95CA6-BF70-4D0C-8A7E-33BDB8A10384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330288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527439366"/>
      </p:ext>
    </p:extLst>
  </p:cSld>
  <p:clrMapOvr>
    <a:masterClrMapping/>
  </p:clrMapOvr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3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4006148"/>
            <a:ext cx="10363200" cy="40075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51F1C5-6C04-4EDA-B243-983EEEB0F2BF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60054679"/>
      </p:ext>
    </p:extLst>
  </p:cSld>
  <p:clrMapOvr>
    <a:masterClrMapping/>
  </p:clrMapOvr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92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24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B425D0-D4E0-4780-9311-9A976DE9DD5E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2504979089"/>
      </p:ext>
    </p:extLst>
  </p:cSld>
  <p:clrMapOvr>
    <a:masterClrMapping/>
  </p:clrMapOvr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712570"/>
            <a:ext cx="5386917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7"/>
            <a:ext cx="5386917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9" y="1712570"/>
            <a:ext cx="5389033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9" y="2174877"/>
            <a:ext cx="5389033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027A89-A72D-45C7-AA52-17571A9E6EAD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213011672"/>
      </p:ext>
    </p:extLst>
  </p:cSld>
  <p:clrMapOvr>
    <a:masterClrMapping/>
  </p:clrMapOvr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57295C-0E15-494C-924B-7EE8AF2737D2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1610432727"/>
      </p:ext>
    </p:extLst>
  </p:cSld>
  <p:clrMapOvr>
    <a:masterClrMapping/>
  </p:clrMapOvr>
</p:sldLayout>
</file>

<file path=ppt/slideLayouts/slideLayout7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72E386-DB3A-4301-996D-7021D7A5512E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2306465466"/>
      </p:ext>
    </p:extLst>
  </p:cSld>
  <p:clrMapOvr>
    <a:masterClrMapping/>
  </p:clrMapOvr>
</p:sldLayout>
</file>

<file path=ppt/slideLayouts/slideLayout7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2"/>
            <a:ext cx="6815667" cy="240129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1435103"/>
            <a:ext cx="4011084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824CC5-D6DA-47AA-9D53-44E9CCFAF42A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1680065747"/>
      </p:ext>
    </p:extLst>
  </p:cSld>
  <p:clrMapOvr>
    <a:masterClrMapping/>
  </p:clrMapOvr>
</p:sldLayout>
</file>

<file path=ppt/slideLayouts/slideLayout7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58541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40"/>
            <a:ext cx="7315200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0E9989-C318-41E6-A66E-039284553653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1865625715"/>
      </p:ext>
    </p:extLst>
  </p:cSld>
  <p:clrMapOvr>
    <a:masterClrMapping/>
  </p:clrMapOvr>
</p:sldLayout>
</file>

<file path=ppt/slideLayouts/slideLayout7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56201" y="1447803"/>
            <a:ext cx="6726200" cy="232435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24530B-4E87-4484-B6FD-DB68F8293BFD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486235088"/>
      </p:ext>
    </p:extLst>
  </p:cSld>
  <p:clrMapOvr>
    <a:masterClrMapping/>
  </p:clrMapOvr>
</p:sldLayout>
</file>

<file path=ppt/slideLayouts/slideLayout7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91600" y="227013"/>
            <a:ext cx="2590800" cy="352266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184" y="227013"/>
            <a:ext cx="2848216" cy="3522662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98433E-ED6A-4081-9823-751F5ACE6DFC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696289309"/>
      </p:ext>
    </p:extLst>
  </p:cSld>
  <p:clrMapOvr>
    <a:masterClrMapping/>
  </p:clrMapOvr>
</p:sldLayout>
</file>

<file path=ppt/slideLayouts/slideLayout7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523862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1850042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240129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331886752"/>
      </p:ext>
    </p:extLst>
  </p:cSld>
  <p:clrMapOvr>
    <a:masterClrMapping/>
  </p:clrMapOvr>
</p:sldLayout>
</file>

<file path=ppt/slideLayouts/slideLayout8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068704517"/>
      </p:ext>
    </p:extLst>
  </p:cSld>
  <p:clrMapOvr>
    <a:masterClrMapping/>
  </p:clrMapOvr>
</p:sldLayout>
</file>

<file path=ppt/slideLayouts/slideLayout8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4006148"/>
            <a:ext cx="10363200" cy="40075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4036772513"/>
      </p:ext>
    </p:extLst>
  </p:cSld>
  <p:clrMapOvr>
    <a:masterClrMapping/>
  </p:clrMapOvr>
</p:sldLayout>
</file>

<file path=ppt/slideLayouts/slideLayout8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92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2400" y="1447801"/>
            <a:ext cx="5080000" cy="2101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535326842"/>
      </p:ext>
    </p:extLst>
  </p:cSld>
  <p:clrMapOvr>
    <a:masterClrMapping/>
  </p:clrMapOvr>
</p:sldLayout>
</file>

<file path=ppt/slideLayouts/slideLayout8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712568"/>
            <a:ext cx="5386917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712568"/>
            <a:ext cx="5389033" cy="4623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18396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729201815"/>
      </p:ext>
    </p:extLst>
  </p:cSld>
  <p:clrMapOvr>
    <a:masterClrMapping/>
  </p:clrMapOvr>
</p:sldLayout>
</file>

<file path=ppt/slideLayouts/slideLayout8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154658773"/>
      </p:ext>
    </p:extLst>
  </p:cSld>
  <p:clrMapOvr>
    <a:masterClrMapping/>
  </p:clrMapOvr>
</p:sldLayout>
</file>

<file path=ppt/slideLayouts/slideLayout8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006062525"/>
      </p:ext>
    </p:extLst>
  </p:cSld>
  <p:clrMapOvr>
    <a:masterClrMapping/>
  </p:clrMapOvr>
</p:sldLayout>
</file>

<file path=ppt/slideLayouts/slideLayout8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240129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734634415"/>
      </p:ext>
    </p:extLst>
  </p:cSld>
  <p:clrMapOvr>
    <a:masterClrMapping/>
  </p:clrMapOvr>
</p:sldLayout>
</file>

<file path=ppt/slideLayouts/slideLayout8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58541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63696109"/>
      </p:ext>
    </p:extLst>
  </p:cSld>
  <p:clrMapOvr>
    <a:masterClrMapping/>
  </p:clrMapOvr>
</p:sldLayout>
</file>

<file path=ppt/slideLayouts/slideLayout8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56200" y="1447801"/>
            <a:ext cx="6726200" cy="232435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080257751"/>
      </p:ext>
    </p:extLst>
  </p:cSld>
  <p:clrMapOvr>
    <a:masterClrMapping/>
  </p:clrMapOvr>
</p:sldLayout>
</file>

<file path=ppt/slideLayouts/slideLayout8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91600" y="227013"/>
            <a:ext cx="2590800" cy="352266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184" y="227013"/>
            <a:ext cx="2848216" cy="3522662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74778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58541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3084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591222835"/>
      </p:ext>
    </p:extLst>
  </p:cSld>
  <p:clrMapOvr>
    <a:masterClrMapping/>
  </p:clrMapOvr>
</p:sldLayout>
</file>

<file path=ppt/slideLayouts/slideLayout90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149968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5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17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6" Type="http://schemas.openxmlformats.org/officeDocument/2006/relationships/slideLayout" Target="../slideLayouts/slideLayout28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6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6.xml"/><Relationship Id="rId3" Type="http://schemas.openxmlformats.org/officeDocument/2006/relationships/slideLayout" Target="../slideLayouts/slideLayout31.xml"/><Relationship Id="rId7" Type="http://schemas.openxmlformats.org/officeDocument/2006/relationships/slideLayout" Target="../slideLayouts/slideLayout35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30.xml"/><Relationship Id="rId1" Type="http://schemas.openxmlformats.org/officeDocument/2006/relationships/slideLayout" Target="../slideLayouts/slideLayout29.xml"/><Relationship Id="rId6" Type="http://schemas.openxmlformats.org/officeDocument/2006/relationships/slideLayout" Target="../slideLayouts/slideLayout34.xml"/><Relationship Id="rId11" Type="http://schemas.openxmlformats.org/officeDocument/2006/relationships/slideLayout" Target="../slideLayouts/slideLayout39.xml"/><Relationship Id="rId5" Type="http://schemas.openxmlformats.org/officeDocument/2006/relationships/slideLayout" Target="../slideLayouts/slideLayout33.xml"/><Relationship Id="rId10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2.xml"/><Relationship Id="rId9" Type="http://schemas.openxmlformats.org/officeDocument/2006/relationships/slideLayout" Target="../slideLayouts/slideLayout37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7.xml"/><Relationship Id="rId13" Type="http://schemas.openxmlformats.org/officeDocument/2006/relationships/theme" Target="../theme/theme4.xml"/><Relationship Id="rId3" Type="http://schemas.openxmlformats.org/officeDocument/2006/relationships/slideLayout" Target="../slideLayouts/slideLayout42.xml"/><Relationship Id="rId7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51.xml"/><Relationship Id="rId2" Type="http://schemas.openxmlformats.org/officeDocument/2006/relationships/slideLayout" Target="../slideLayouts/slideLayout41.xml"/><Relationship Id="rId1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50.xml"/><Relationship Id="rId5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9.xml"/><Relationship Id="rId4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8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4.xml"/><Relationship Id="rId3" Type="http://schemas.openxmlformats.org/officeDocument/2006/relationships/slideLayout" Target="../slideLayouts/slideLayout54.xml"/><Relationship Id="rId7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63.xml"/><Relationship Id="rId17" Type="http://schemas.openxmlformats.org/officeDocument/2006/relationships/theme" Target="../theme/theme5.xml"/><Relationship Id="rId2" Type="http://schemas.openxmlformats.org/officeDocument/2006/relationships/slideLayout" Target="../slideLayouts/slideLayout53.xml"/><Relationship Id="rId16" Type="http://schemas.openxmlformats.org/officeDocument/2006/relationships/slideLayout" Target="../slideLayouts/slideLayout67.xml"/><Relationship Id="rId1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62.xml"/><Relationship Id="rId5" Type="http://schemas.openxmlformats.org/officeDocument/2006/relationships/slideLayout" Target="../slideLayouts/slideLayout56.xml"/><Relationship Id="rId15" Type="http://schemas.openxmlformats.org/officeDocument/2006/relationships/slideLayout" Target="../slideLayouts/slideLayout66.xml"/><Relationship Id="rId10" Type="http://schemas.openxmlformats.org/officeDocument/2006/relationships/slideLayout" Target="../slideLayouts/slideLayout61.xml"/><Relationship Id="rId4" Type="http://schemas.openxmlformats.org/officeDocument/2006/relationships/slideLayout" Target="../slideLayouts/slideLayout55.xml"/><Relationship Id="rId9" Type="http://schemas.openxmlformats.org/officeDocument/2006/relationships/slideLayout" Target="../slideLayouts/slideLayout60.xml"/><Relationship Id="rId14" Type="http://schemas.openxmlformats.org/officeDocument/2006/relationships/slideLayout" Target="../slideLayouts/slideLayout65.xml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5.xml"/><Relationship Id="rId3" Type="http://schemas.openxmlformats.org/officeDocument/2006/relationships/slideLayout" Target="../slideLayouts/slideLayout70.xml"/><Relationship Id="rId7" Type="http://schemas.openxmlformats.org/officeDocument/2006/relationships/slideLayout" Target="../slideLayouts/slideLayout74.xml"/><Relationship Id="rId12" Type="http://schemas.openxmlformats.org/officeDocument/2006/relationships/theme" Target="../theme/theme6.xml"/><Relationship Id="rId2" Type="http://schemas.openxmlformats.org/officeDocument/2006/relationships/slideLayout" Target="../slideLayouts/slideLayout69.xml"/><Relationship Id="rId1" Type="http://schemas.openxmlformats.org/officeDocument/2006/relationships/slideLayout" Target="../slideLayouts/slideLayout68.xml"/><Relationship Id="rId6" Type="http://schemas.openxmlformats.org/officeDocument/2006/relationships/slideLayout" Target="../slideLayouts/slideLayout73.xml"/><Relationship Id="rId11" Type="http://schemas.openxmlformats.org/officeDocument/2006/relationships/slideLayout" Target="../slideLayouts/slideLayout78.xml"/><Relationship Id="rId5" Type="http://schemas.openxmlformats.org/officeDocument/2006/relationships/slideLayout" Target="../slideLayouts/slideLayout72.xml"/><Relationship Id="rId10" Type="http://schemas.openxmlformats.org/officeDocument/2006/relationships/slideLayout" Target="../slideLayouts/slideLayout77.xml"/><Relationship Id="rId4" Type="http://schemas.openxmlformats.org/officeDocument/2006/relationships/slideLayout" Target="../slideLayouts/slideLayout71.xml"/><Relationship Id="rId9" Type="http://schemas.openxmlformats.org/officeDocument/2006/relationships/slideLayout" Target="../slideLayouts/slideLayout76.xml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6.xml"/><Relationship Id="rId13" Type="http://schemas.openxmlformats.org/officeDocument/2006/relationships/theme" Target="../theme/theme7.xml"/><Relationship Id="rId3" Type="http://schemas.openxmlformats.org/officeDocument/2006/relationships/slideLayout" Target="../slideLayouts/slideLayout81.xml"/><Relationship Id="rId7" Type="http://schemas.openxmlformats.org/officeDocument/2006/relationships/slideLayout" Target="../slideLayouts/slideLayout85.xml"/><Relationship Id="rId12" Type="http://schemas.openxmlformats.org/officeDocument/2006/relationships/slideLayout" Target="../slideLayouts/slideLayout90.xml"/><Relationship Id="rId2" Type="http://schemas.openxmlformats.org/officeDocument/2006/relationships/slideLayout" Target="../slideLayouts/slideLayout80.xml"/><Relationship Id="rId1" Type="http://schemas.openxmlformats.org/officeDocument/2006/relationships/slideLayout" Target="../slideLayouts/slideLayout79.xml"/><Relationship Id="rId6" Type="http://schemas.openxmlformats.org/officeDocument/2006/relationships/slideLayout" Target="../slideLayouts/slideLayout84.xml"/><Relationship Id="rId11" Type="http://schemas.openxmlformats.org/officeDocument/2006/relationships/slideLayout" Target="../slideLayouts/slideLayout89.xml"/><Relationship Id="rId5" Type="http://schemas.openxmlformats.org/officeDocument/2006/relationships/slideLayout" Target="../slideLayouts/slideLayout83.xml"/><Relationship Id="rId10" Type="http://schemas.openxmlformats.org/officeDocument/2006/relationships/slideLayout" Target="../slideLayouts/slideLayout88.xml"/><Relationship Id="rId4" Type="http://schemas.openxmlformats.org/officeDocument/2006/relationships/slideLayout" Target="../slideLayouts/slideLayout82.xml"/><Relationship Id="rId9" Type="http://schemas.openxmlformats.org/officeDocument/2006/relationships/slideLayout" Target="../slideLayouts/slideLayout8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4"/>
          <p:cNvSpPr>
            <a:spLocks noChangeArrowheads="1"/>
          </p:cNvSpPr>
          <p:nvPr/>
        </p:nvSpPr>
        <p:spPr bwMode="auto">
          <a:xfrm>
            <a:off x="0" y="0"/>
            <a:ext cx="609600" cy="6858000"/>
          </a:xfrm>
          <a:prstGeom prst="rect">
            <a:avLst/>
          </a:prstGeom>
          <a:gradFill rotWithShape="0">
            <a:gsLst>
              <a:gs pos="0">
                <a:schemeClr val="tx2"/>
              </a:gs>
              <a:gs pos="100000">
                <a:schemeClr val="accent1"/>
              </a:gs>
            </a:gsLst>
            <a:lin ang="5400000" scaled="1"/>
          </a:gradFill>
          <a:ln>
            <a:noFill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altLang="en-US" dirty="0"/>
          </a:p>
        </p:txBody>
      </p:sp>
      <p:sp>
        <p:nvSpPr>
          <p:cNvPr id="1027" name="Line 6"/>
          <p:cNvSpPr>
            <a:spLocks noChangeShapeType="1"/>
          </p:cNvSpPr>
          <p:nvPr/>
        </p:nvSpPr>
        <p:spPr bwMode="auto">
          <a:xfrm>
            <a:off x="1219200" y="2970213"/>
            <a:ext cx="10363200" cy="0"/>
          </a:xfrm>
          <a:prstGeom prst="line">
            <a:avLst/>
          </a:prstGeom>
          <a:noFill/>
          <a:ln w="25400">
            <a:solidFill>
              <a:schemeClr val="tx2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dirty="0"/>
          </a:p>
        </p:txBody>
      </p:sp>
      <p:sp>
        <p:nvSpPr>
          <p:cNvPr id="1029" name="Rectangle 3"/>
          <p:cNvSpPr>
            <a:spLocks noGrp="1" noChangeArrowheads="1"/>
          </p:cNvSpPr>
          <p:nvPr>
            <p:ph type="title"/>
          </p:nvPr>
        </p:nvSpPr>
        <p:spPr bwMode="auto">
          <a:xfrm>
            <a:off x="1219200" y="227013"/>
            <a:ext cx="103632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30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1219200" y="1447800"/>
            <a:ext cx="10363200" cy="2324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t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30" r:id="rId1"/>
    <p:sldLayoutId id="2147483831" r:id="rId2"/>
    <p:sldLayoutId id="2147483832" r:id="rId3"/>
    <p:sldLayoutId id="2147483833" r:id="rId4"/>
    <p:sldLayoutId id="2147483834" r:id="rId5"/>
    <p:sldLayoutId id="2147483835" r:id="rId6"/>
    <p:sldLayoutId id="2147483836" r:id="rId7"/>
    <p:sldLayoutId id="2147483837" r:id="rId8"/>
    <p:sldLayoutId id="2147483838" r:id="rId9"/>
    <p:sldLayoutId id="2147483839" r:id="rId10"/>
    <p:sldLayoutId id="2147483840" r:id="rId11"/>
    <p:sldLayoutId id="2147483841" r:id="rId12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</a:defRPr>
      </a:lvl2pPr>
      <a:lvl3pPr marL="11430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400">
          <a:solidFill>
            <a:schemeClr val="accent1"/>
          </a:solidFill>
          <a:latin typeface="+mn-lt"/>
        </a:defRPr>
      </a:lvl3pPr>
      <a:lvl4pPr marL="16002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4pPr>
      <a:lvl5pPr marL="20574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5pPr>
      <a:lvl6pPr marL="25146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6pPr>
      <a:lvl7pPr marL="29718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7pPr>
      <a:lvl8pPr marL="34290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8pPr>
      <a:lvl9pPr marL="38862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ChangeArrowheads="1"/>
          </p:cNvSpPr>
          <p:nvPr/>
        </p:nvSpPr>
        <p:spPr bwMode="auto">
          <a:xfrm>
            <a:off x="0" y="0"/>
            <a:ext cx="609600" cy="6858000"/>
          </a:xfrm>
          <a:prstGeom prst="rect">
            <a:avLst/>
          </a:prstGeom>
          <a:gradFill rotWithShape="0">
            <a:gsLst>
              <a:gs pos="0">
                <a:schemeClr val="tx2"/>
              </a:gs>
              <a:gs pos="100000">
                <a:schemeClr val="accent1"/>
              </a:gs>
            </a:gsLst>
            <a:lin ang="5400000" scaled="1"/>
          </a:gradFill>
          <a:ln>
            <a:noFill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altLang="en-US" dirty="0"/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title"/>
          </p:nvPr>
        </p:nvSpPr>
        <p:spPr bwMode="auto">
          <a:xfrm>
            <a:off x="1219200" y="227013"/>
            <a:ext cx="103632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2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1219200" y="1447800"/>
            <a:ext cx="10363200" cy="2324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t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2053" name="Line 5"/>
          <p:cNvSpPr>
            <a:spLocks noChangeShapeType="1"/>
          </p:cNvSpPr>
          <p:nvPr/>
        </p:nvSpPr>
        <p:spPr bwMode="auto">
          <a:xfrm>
            <a:off x="1219200" y="1295400"/>
            <a:ext cx="10363200" cy="0"/>
          </a:xfrm>
          <a:prstGeom prst="line">
            <a:avLst/>
          </a:prstGeom>
          <a:noFill/>
          <a:ln w="25400">
            <a:solidFill>
              <a:schemeClr val="tx2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42" r:id="rId1"/>
    <p:sldLayoutId id="2147483843" r:id="rId2"/>
    <p:sldLayoutId id="2147483844" r:id="rId3"/>
    <p:sldLayoutId id="2147483845" r:id="rId4"/>
    <p:sldLayoutId id="2147483846" r:id="rId5"/>
    <p:sldLayoutId id="2147483847" r:id="rId6"/>
    <p:sldLayoutId id="2147483848" r:id="rId7"/>
    <p:sldLayoutId id="2147483849" r:id="rId8"/>
    <p:sldLayoutId id="2147483850" r:id="rId9"/>
    <p:sldLayoutId id="2147483851" r:id="rId10"/>
    <p:sldLayoutId id="2147483852" r:id="rId11"/>
    <p:sldLayoutId id="2147483853" r:id="rId12"/>
    <p:sldLayoutId id="2147483854" r:id="rId13"/>
    <p:sldLayoutId id="2147483855" r:id="rId14"/>
    <p:sldLayoutId id="2147483856" r:id="rId15"/>
    <p:sldLayoutId id="2147483857" r:id="rId16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</a:defRPr>
      </a:lvl2pPr>
      <a:lvl3pPr marL="11430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400">
          <a:solidFill>
            <a:schemeClr val="accent1"/>
          </a:solidFill>
          <a:latin typeface="+mn-lt"/>
        </a:defRPr>
      </a:lvl3pPr>
      <a:lvl4pPr marL="16002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4pPr>
      <a:lvl5pPr marL="20574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5pPr>
      <a:lvl6pPr marL="25146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6pPr>
      <a:lvl7pPr marL="29718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7pPr>
      <a:lvl8pPr marL="34290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8pPr>
      <a:lvl9pPr marL="38862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0" y="0"/>
            <a:ext cx="609600" cy="6858000"/>
          </a:xfrm>
          <a:prstGeom prst="rect">
            <a:avLst/>
          </a:prstGeom>
          <a:gradFill rotWithShape="0">
            <a:gsLst>
              <a:gs pos="0">
                <a:schemeClr val="tx2"/>
              </a:gs>
              <a:gs pos="100000">
                <a:schemeClr val="accent1"/>
              </a:gs>
            </a:gsLst>
            <a:lin ang="5400000" scaled="1"/>
          </a:gradFill>
          <a:ln>
            <a:noFill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altLang="en-US" dirty="0"/>
          </a:p>
        </p:txBody>
      </p:sp>
      <p:sp>
        <p:nvSpPr>
          <p:cNvPr id="3075" name="Line 5"/>
          <p:cNvSpPr>
            <a:spLocks noChangeShapeType="1"/>
          </p:cNvSpPr>
          <p:nvPr/>
        </p:nvSpPr>
        <p:spPr bwMode="auto">
          <a:xfrm>
            <a:off x="1219200" y="1295400"/>
            <a:ext cx="10363200" cy="0"/>
          </a:xfrm>
          <a:prstGeom prst="line">
            <a:avLst/>
          </a:prstGeom>
          <a:noFill/>
          <a:ln w="25400">
            <a:solidFill>
              <a:schemeClr val="tx2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dirty="0"/>
          </a:p>
        </p:txBody>
      </p:sp>
      <p:sp>
        <p:nvSpPr>
          <p:cNvPr id="3077" name="Rectangle 3"/>
          <p:cNvSpPr>
            <a:spLocks noGrp="1" noChangeArrowheads="1"/>
          </p:cNvSpPr>
          <p:nvPr>
            <p:ph type="title"/>
          </p:nvPr>
        </p:nvSpPr>
        <p:spPr bwMode="auto">
          <a:xfrm>
            <a:off x="1219200" y="227013"/>
            <a:ext cx="103632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8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1219200" y="1447800"/>
            <a:ext cx="10363200" cy="2324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t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2"/>
          </p:nvPr>
        </p:nvSpPr>
        <p:spPr>
          <a:xfrm>
            <a:off x="609600" y="6245225"/>
            <a:ext cx="2844800" cy="476250"/>
          </a:xfrm>
          <a:prstGeom prst="rect">
            <a:avLst/>
          </a:prstGeom>
        </p:spPr>
        <p:txBody>
          <a:bodyPr/>
          <a:lstStyle>
            <a:lvl1pPr eaLnBrk="1" fontAlgn="auto" hangingPunct="1">
              <a:spcBef>
                <a:spcPts val="0"/>
              </a:spcBef>
              <a:spcAft>
                <a:spcPts val="0"/>
              </a:spcAft>
              <a:defRPr>
                <a:latin typeface="+mn-lt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3"/>
          </p:nvPr>
        </p:nvSpPr>
        <p:spPr>
          <a:xfrm>
            <a:off x="4165600" y="6245225"/>
            <a:ext cx="3860800" cy="476250"/>
          </a:xfrm>
          <a:prstGeom prst="rect">
            <a:avLst/>
          </a:prstGeom>
        </p:spPr>
        <p:txBody>
          <a:bodyPr/>
          <a:lstStyle>
            <a:lvl1pPr eaLnBrk="1" fontAlgn="auto" hangingPunct="1">
              <a:spcBef>
                <a:spcPts val="0"/>
              </a:spcBef>
              <a:spcAft>
                <a:spcPts val="0"/>
              </a:spcAft>
              <a:defRPr>
                <a:latin typeface="+mn-lt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4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/>
            </a:lvl1pPr>
          </a:lstStyle>
          <a:p>
            <a:pPr>
              <a:defRPr/>
            </a:pPr>
            <a:fld id="{C8ED0648-88D6-4ADF-B24F-C89605811C0A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58" r:id="rId1"/>
    <p:sldLayoutId id="2147483859" r:id="rId2"/>
    <p:sldLayoutId id="2147483860" r:id="rId3"/>
    <p:sldLayoutId id="2147483861" r:id="rId4"/>
    <p:sldLayoutId id="2147483862" r:id="rId5"/>
    <p:sldLayoutId id="2147483863" r:id="rId6"/>
    <p:sldLayoutId id="2147483864" r:id="rId7"/>
    <p:sldLayoutId id="2147483865" r:id="rId8"/>
    <p:sldLayoutId id="2147483866" r:id="rId9"/>
    <p:sldLayoutId id="2147483867" r:id="rId10"/>
    <p:sldLayoutId id="2147483868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</a:defRPr>
      </a:lvl2pPr>
      <a:lvl3pPr marL="11430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400">
          <a:solidFill>
            <a:schemeClr val="accent1"/>
          </a:solidFill>
          <a:latin typeface="+mn-lt"/>
        </a:defRPr>
      </a:lvl3pPr>
      <a:lvl4pPr marL="16002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4pPr>
      <a:lvl5pPr marL="20574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5pPr>
      <a:lvl6pPr marL="25146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6pPr>
      <a:lvl7pPr marL="29718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7pPr>
      <a:lvl8pPr marL="34290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8pPr>
      <a:lvl9pPr marL="38862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4"/>
          <p:cNvSpPr>
            <a:spLocks noChangeArrowheads="1"/>
          </p:cNvSpPr>
          <p:nvPr/>
        </p:nvSpPr>
        <p:spPr bwMode="auto">
          <a:xfrm>
            <a:off x="0" y="0"/>
            <a:ext cx="609600" cy="6858000"/>
          </a:xfrm>
          <a:prstGeom prst="rect">
            <a:avLst/>
          </a:prstGeom>
          <a:gradFill rotWithShape="0">
            <a:gsLst>
              <a:gs pos="0">
                <a:schemeClr val="tx2"/>
              </a:gs>
              <a:gs pos="100000">
                <a:schemeClr val="accent1"/>
              </a:gs>
            </a:gsLst>
            <a:lin ang="5400000" scaled="1"/>
          </a:gradFill>
          <a:ln>
            <a:noFill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altLang="en-US" dirty="0"/>
          </a:p>
        </p:txBody>
      </p:sp>
      <p:sp>
        <p:nvSpPr>
          <p:cNvPr id="4099" name="Line 6"/>
          <p:cNvSpPr>
            <a:spLocks noChangeShapeType="1"/>
          </p:cNvSpPr>
          <p:nvPr/>
        </p:nvSpPr>
        <p:spPr bwMode="auto">
          <a:xfrm>
            <a:off x="1219200" y="2970213"/>
            <a:ext cx="10363200" cy="0"/>
          </a:xfrm>
          <a:prstGeom prst="line">
            <a:avLst/>
          </a:prstGeom>
          <a:noFill/>
          <a:ln w="25400">
            <a:solidFill>
              <a:schemeClr val="tx2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dirty="0"/>
          </a:p>
        </p:txBody>
      </p:sp>
      <p:sp>
        <p:nvSpPr>
          <p:cNvPr id="4100" name="Rectangle 3"/>
          <p:cNvSpPr>
            <a:spLocks noGrp="1" noChangeArrowheads="1"/>
          </p:cNvSpPr>
          <p:nvPr>
            <p:ph type="title"/>
          </p:nvPr>
        </p:nvSpPr>
        <p:spPr bwMode="auto">
          <a:xfrm>
            <a:off x="1219200" y="227013"/>
            <a:ext cx="103632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4101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1219200" y="1447800"/>
            <a:ext cx="10363200" cy="2324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t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69" r:id="rId1"/>
    <p:sldLayoutId id="2147483870" r:id="rId2"/>
    <p:sldLayoutId id="2147483871" r:id="rId3"/>
    <p:sldLayoutId id="2147483872" r:id="rId4"/>
    <p:sldLayoutId id="2147483873" r:id="rId5"/>
    <p:sldLayoutId id="2147483874" r:id="rId6"/>
    <p:sldLayoutId id="2147483875" r:id="rId7"/>
    <p:sldLayoutId id="2147483876" r:id="rId8"/>
    <p:sldLayoutId id="2147483877" r:id="rId9"/>
    <p:sldLayoutId id="2147483878" r:id="rId10"/>
    <p:sldLayoutId id="2147483879" r:id="rId11"/>
    <p:sldLayoutId id="2147483880" r:id="rId12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</a:defRPr>
      </a:lvl2pPr>
      <a:lvl3pPr marL="11430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400">
          <a:solidFill>
            <a:schemeClr val="accent1"/>
          </a:solidFill>
          <a:latin typeface="+mn-lt"/>
        </a:defRPr>
      </a:lvl3pPr>
      <a:lvl4pPr marL="16002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4pPr>
      <a:lvl5pPr marL="20574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5pPr>
      <a:lvl6pPr marL="25146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6pPr>
      <a:lvl7pPr marL="29718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7pPr>
      <a:lvl8pPr marL="34290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8pPr>
      <a:lvl9pPr marL="38862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ChangeArrowheads="1"/>
          </p:cNvSpPr>
          <p:nvPr/>
        </p:nvSpPr>
        <p:spPr bwMode="auto">
          <a:xfrm>
            <a:off x="0" y="0"/>
            <a:ext cx="609600" cy="6858000"/>
          </a:xfrm>
          <a:prstGeom prst="rect">
            <a:avLst/>
          </a:prstGeom>
          <a:gradFill rotWithShape="0">
            <a:gsLst>
              <a:gs pos="0">
                <a:schemeClr val="tx2"/>
              </a:gs>
              <a:gs pos="100000">
                <a:schemeClr val="accent1"/>
              </a:gs>
            </a:gsLst>
            <a:lin ang="5400000" scaled="1"/>
          </a:gradFill>
          <a:ln>
            <a:noFill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altLang="en-US" dirty="0"/>
          </a:p>
        </p:txBody>
      </p:sp>
      <p:sp>
        <p:nvSpPr>
          <p:cNvPr id="5123" name="Rectangle 3"/>
          <p:cNvSpPr>
            <a:spLocks noGrp="1" noChangeArrowheads="1"/>
          </p:cNvSpPr>
          <p:nvPr>
            <p:ph type="title"/>
          </p:nvPr>
        </p:nvSpPr>
        <p:spPr bwMode="auto">
          <a:xfrm>
            <a:off x="1219200" y="227013"/>
            <a:ext cx="103632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5124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1219200" y="1447800"/>
            <a:ext cx="10363200" cy="2324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t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5125" name="Line 5"/>
          <p:cNvSpPr>
            <a:spLocks noChangeShapeType="1"/>
          </p:cNvSpPr>
          <p:nvPr/>
        </p:nvSpPr>
        <p:spPr bwMode="auto">
          <a:xfrm>
            <a:off x="1219200" y="1295400"/>
            <a:ext cx="10363200" cy="0"/>
          </a:xfrm>
          <a:prstGeom prst="line">
            <a:avLst/>
          </a:prstGeom>
          <a:noFill/>
          <a:ln w="25400">
            <a:solidFill>
              <a:schemeClr val="tx2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81" r:id="rId1"/>
    <p:sldLayoutId id="2147483882" r:id="rId2"/>
    <p:sldLayoutId id="2147483883" r:id="rId3"/>
    <p:sldLayoutId id="2147483884" r:id="rId4"/>
    <p:sldLayoutId id="2147483885" r:id="rId5"/>
    <p:sldLayoutId id="2147483886" r:id="rId6"/>
    <p:sldLayoutId id="2147483887" r:id="rId7"/>
    <p:sldLayoutId id="2147483888" r:id="rId8"/>
    <p:sldLayoutId id="2147483889" r:id="rId9"/>
    <p:sldLayoutId id="2147483890" r:id="rId10"/>
    <p:sldLayoutId id="2147483891" r:id="rId11"/>
    <p:sldLayoutId id="2147483892" r:id="rId12"/>
    <p:sldLayoutId id="2147483893" r:id="rId13"/>
    <p:sldLayoutId id="2147483894" r:id="rId14"/>
    <p:sldLayoutId id="2147483895" r:id="rId15"/>
    <p:sldLayoutId id="2147483896" r:id="rId16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Arial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</a:defRPr>
      </a:lvl2pPr>
      <a:lvl3pPr marL="11430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400">
          <a:solidFill>
            <a:schemeClr val="accent1"/>
          </a:solidFill>
          <a:latin typeface="+mn-lt"/>
        </a:defRPr>
      </a:lvl3pPr>
      <a:lvl4pPr marL="16002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4pPr>
      <a:lvl5pPr marL="20574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5pPr>
      <a:lvl6pPr marL="25146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6pPr>
      <a:lvl7pPr marL="29718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7pPr>
      <a:lvl8pPr marL="34290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8pPr>
      <a:lvl9pPr marL="38862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0" y="0"/>
            <a:ext cx="609600" cy="6858000"/>
          </a:xfrm>
          <a:prstGeom prst="rect">
            <a:avLst/>
          </a:prstGeom>
          <a:gradFill rotWithShape="0">
            <a:gsLst>
              <a:gs pos="0">
                <a:schemeClr val="tx2"/>
              </a:gs>
              <a:gs pos="100000">
                <a:schemeClr val="accent1"/>
              </a:gs>
            </a:gsLst>
            <a:lin ang="5400000" scaled="1"/>
          </a:gradFill>
          <a:ln>
            <a:noFill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altLang="en-US" dirty="0"/>
          </a:p>
        </p:txBody>
      </p:sp>
      <p:sp>
        <p:nvSpPr>
          <p:cNvPr id="6147" name="Line 5"/>
          <p:cNvSpPr>
            <a:spLocks noChangeShapeType="1"/>
          </p:cNvSpPr>
          <p:nvPr/>
        </p:nvSpPr>
        <p:spPr bwMode="auto">
          <a:xfrm>
            <a:off x="1219200" y="1295400"/>
            <a:ext cx="10363200" cy="0"/>
          </a:xfrm>
          <a:prstGeom prst="line">
            <a:avLst/>
          </a:prstGeom>
          <a:noFill/>
          <a:ln w="25400">
            <a:solidFill>
              <a:schemeClr val="tx2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dirty="0"/>
          </a:p>
        </p:txBody>
      </p:sp>
      <p:sp>
        <p:nvSpPr>
          <p:cNvPr id="6148" name="Rectangle 3"/>
          <p:cNvSpPr>
            <a:spLocks noGrp="1" noChangeArrowheads="1"/>
          </p:cNvSpPr>
          <p:nvPr>
            <p:ph type="title"/>
          </p:nvPr>
        </p:nvSpPr>
        <p:spPr bwMode="auto">
          <a:xfrm>
            <a:off x="1219200" y="227013"/>
            <a:ext cx="103632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6149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1219200" y="1447800"/>
            <a:ext cx="10363200" cy="2324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t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2"/>
          </p:nvPr>
        </p:nvSpPr>
        <p:spPr>
          <a:xfrm>
            <a:off x="609600" y="6245225"/>
            <a:ext cx="2844800" cy="476250"/>
          </a:xfrm>
          <a:prstGeom prst="rect">
            <a:avLst/>
          </a:prstGeom>
        </p:spPr>
        <p:txBody>
          <a:bodyPr/>
          <a:lstStyle>
            <a:lvl1pPr eaLnBrk="1" fontAlgn="auto" hangingPunct="1">
              <a:spcBef>
                <a:spcPts val="0"/>
              </a:spcBef>
              <a:spcAft>
                <a:spcPts val="0"/>
              </a:spcAft>
              <a:defRPr>
                <a:latin typeface="+mn-lt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3"/>
          </p:nvPr>
        </p:nvSpPr>
        <p:spPr>
          <a:xfrm>
            <a:off x="4165600" y="6245225"/>
            <a:ext cx="3860800" cy="476250"/>
          </a:xfrm>
          <a:prstGeom prst="rect">
            <a:avLst/>
          </a:prstGeom>
        </p:spPr>
        <p:txBody>
          <a:bodyPr/>
          <a:lstStyle>
            <a:lvl1pPr eaLnBrk="1" fontAlgn="auto" hangingPunct="1">
              <a:spcBef>
                <a:spcPts val="0"/>
              </a:spcBef>
              <a:spcAft>
                <a:spcPts val="0"/>
              </a:spcAft>
              <a:defRPr>
                <a:latin typeface="+mn-lt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4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/>
            </a:lvl1pPr>
          </a:lstStyle>
          <a:p>
            <a:pPr>
              <a:defRPr/>
            </a:pPr>
            <a:fld id="{A7F15C0D-3418-4552-AFF7-49DE47EE3015}" type="slidenum">
              <a:rPr lang="en-US" altLang="en-US"/>
              <a:pPr>
                <a:defRPr/>
              </a:pPr>
              <a:t>‹#›</a:t>
            </a:fld>
            <a:endParaRPr lang="en-US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97" r:id="rId1"/>
    <p:sldLayoutId id="2147483898" r:id="rId2"/>
    <p:sldLayoutId id="2147483899" r:id="rId3"/>
    <p:sldLayoutId id="2147483900" r:id="rId4"/>
    <p:sldLayoutId id="2147483901" r:id="rId5"/>
    <p:sldLayoutId id="2147483902" r:id="rId6"/>
    <p:sldLayoutId id="2147483903" r:id="rId7"/>
    <p:sldLayoutId id="2147483904" r:id="rId8"/>
    <p:sldLayoutId id="2147483905" r:id="rId9"/>
    <p:sldLayoutId id="2147483906" r:id="rId10"/>
    <p:sldLayoutId id="2147483907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</a:defRPr>
      </a:lvl2pPr>
      <a:lvl3pPr marL="11430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400">
          <a:solidFill>
            <a:schemeClr val="accent1"/>
          </a:solidFill>
          <a:latin typeface="+mn-lt"/>
        </a:defRPr>
      </a:lvl3pPr>
      <a:lvl4pPr marL="16002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4pPr>
      <a:lvl5pPr marL="20574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5pPr>
      <a:lvl6pPr marL="25146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6pPr>
      <a:lvl7pPr marL="29718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7pPr>
      <a:lvl8pPr marL="34290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8pPr>
      <a:lvl9pPr marL="38862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4"/>
          <p:cNvSpPr>
            <a:spLocks noChangeArrowheads="1"/>
          </p:cNvSpPr>
          <p:nvPr/>
        </p:nvSpPr>
        <p:spPr bwMode="auto">
          <a:xfrm>
            <a:off x="0" y="0"/>
            <a:ext cx="609600" cy="6858000"/>
          </a:xfrm>
          <a:prstGeom prst="rect">
            <a:avLst/>
          </a:prstGeom>
          <a:gradFill rotWithShape="0">
            <a:gsLst>
              <a:gs pos="0">
                <a:schemeClr val="tx2"/>
              </a:gs>
              <a:gs pos="100000">
                <a:schemeClr val="accent1"/>
              </a:gs>
            </a:gsLst>
            <a:lin ang="5400000" scaled="1"/>
          </a:gradFill>
          <a:ln>
            <a:noFill/>
          </a:ln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Book Antiqua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Book Antiqua" pitchFamily="18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altLang="en-US" dirty="0"/>
          </a:p>
        </p:txBody>
      </p:sp>
      <p:sp>
        <p:nvSpPr>
          <p:cNvPr id="7171" name="Line 6"/>
          <p:cNvSpPr>
            <a:spLocks noChangeShapeType="1"/>
          </p:cNvSpPr>
          <p:nvPr/>
        </p:nvSpPr>
        <p:spPr bwMode="auto">
          <a:xfrm>
            <a:off x="1219200" y="2970213"/>
            <a:ext cx="10363200" cy="0"/>
          </a:xfrm>
          <a:prstGeom prst="line">
            <a:avLst/>
          </a:prstGeom>
          <a:noFill/>
          <a:ln w="25400">
            <a:solidFill>
              <a:schemeClr val="tx2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dirty="0"/>
          </a:p>
        </p:txBody>
      </p:sp>
      <p:sp>
        <p:nvSpPr>
          <p:cNvPr id="7173" name="Rectangle 3"/>
          <p:cNvSpPr>
            <a:spLocks noGrp="1" noChangeArrowheads="1"/>
          </p:cNvSpPr>
          <p:nvPr>
            <p:ph type="title"/>
          </p:nvPr>
        </p:nvSpPr>
        <p:spPr bwMode="auto">
          <a:xfrm>
            <a:off x="1219200" y="227013"/>
            <a:ext cx="103632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7174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1219200" y="1447800"/>
            <a:ext cx="10363200" cy="2324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075" tIns="46038" rIns="92075" bIns="46038" numCol="1" anchor="t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08" r:id="rId1"/>
    <p:sldLayoutId id="2147483909" r:id="rId2"/>
    <p:sldLayoutId id="2147483910" r:id="rId3"/>
    <p:sldLayoutId id="2147483911" r:id="rId4"/>
    <p:sldLayoutId id="2147483912" r:id="rId5"/>
    <p:sldLayoutId id="2147483913" r:id="rId6"/>
    <p:sldLayoutId id="2147483914" r:id="rId7"/>
    <p:sldLayoutId id="2147483915" r:id="rId8"/>
    <p:sldLayoutId id="2147483916" r:id="rId9"/>
    <p:sldLayoutId id="2147483917" r:id="rId10"/>
    <p:sldLayoutId id="2147483918" r:id="rId11"/>
    <p:sldLayoutId id="2147483919" r:id="rId12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2"/>
          </a:solidFill>
          <a:latin typeface="Trebuchet MS" pitchFamily="34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800">
          <a:solidFill>
            <a:schemeClr val="accent1"/>
          </a:solidFill>
          <a:latin typeface="+mn-lt"/>
        </a:defRPr>
      </a:lvl2pPr>
      <a:lvl3pPr marL="11430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400">
          <a:solidFill>
            <a:schemeClr val="accent1"/>
          </a:solidFill>
          <a:latin typeface="+mn-lt"/>
        </a:defRPr>
      </a:lvl3pPr>
      <a:lvl4pPr marL="16002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4pPr>
      <a:lvl5pPr marL="2057400" indent="-228600" algn="l" rtl="0" eaLnBrk="0" fontAlgn="base" hangingPunct="0">
        <a:spcBef>
          <a:spcPct val="0"/>
        </a:spcBef>
        <a:spcAft>
          <a:spcPct val="25000"/>
        </a:spcAft>
        <a:buClr>
          <a:schemeClr val="tx2"/>
        </a:buClr>
        <a:buFont typeface="Wingdings" panose="05000000000000000000" pitchFamily="2" charset="2"/>
        <a:buChar char="§"/>
        <a:defRPr sz="2000">
          <a:solidFill>
            <a:schemeClr val="accent1"/>
          </a:solidFill>
          <a:latin typeface="+mn-lt"/>
        </a:defRPr>
      </a:lvl5pPr>
      <a:lvl6pPr marL="25146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6pPr>
      <a:lvl7pPr marL="29718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7pPr>
      <a:lvl8pPr marL="34290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8pPr>
      <a:lvl9pPr marL="3886200" indent="-228600" algn="l" rtl="0" eaLnBrk="1" fontAlgn="base" hangingPunct="1">
        <a:spcBef>
          <a:spcPct val="0"/>
        </a:spcBef>
        <a:spcAft>
          <a:spcPct val="25000"/>
        </a:spcAft>
        <a:buClr>
          <a:schemeClr val="tx2"/>
        </a:buClr>
        <a:buFont typeface="Wingdings" pitchFamily="2" charset="2"/>
        <a:buChar char="§"/>
        <a:defRPr sz="2000">
          <a:solidFill>
            <a:schemeClr val="accent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B70BD82-AEBF-454A-9E48-4E83B6448D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7567" y="742840"/>
            <a:ext cx="7566764" cy="536441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A5ADD03-88EA-44A7-8CDA-0F898D15A84F}"/>
              </a:ext>
            </a:extLst>
          </p:cNvPr>
          <p:cNvSpPr txBox="1"/>
          <p:nvPr/>
        </p:nvSpPr>
        <p:spPr>
          <a:xfrm>
            <a:off x="8276665" y="1575547"/>
            <a:ext cx="3583641" cy="31700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Q: The lesion within the paramidline dorsal pons could result in which of the following deficits?​</a:t>
            </a: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​</a:t>
            </a: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A. Facial paralysis</a:t>
            </a: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B. Esotropia</a:t>
            </a:r>
            <a:endParaRPr lang="en-US" sz="2000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C. Vertigo</a:t>
            </a:r>
            <a:endParaRPr lang="en-US" sz="2000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D. Hearing loss</a:t>
            </a:r>
            <a:endParaRPr lang="en-US" sz="2000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E. A and B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6265843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1ABA8E4-2CEB-43E1-B831-B1AF34431044}"/>
              </a:ext>
            </a:extLst>
          </p:cNvPr>
          <p:cNvSpPr txBox="1"/>
          <p:nvPr/>
        </p:nvSpPr>
        <p:spPr>
          <a:xfrm>
            <a:off x="1054100" y="241300"/>
            <a:ext cx="10350500" cy="624786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4000" dirty="0">
                <a:solidFill>
                  <a:srgbClr val="FFFFFF"/>
                </a:solidFill>
                <a:latin typeface="Calibri"/>
                <a:cs typeface="Calibri"/>
              </a:rPr>
              <a:t>Q: Overall, how confident were you in the answer to the previous questions on a scale of 1 to 5, with 1 being not confident and 5 being very confident?​</a:t>
            </a:r>
          </a:p>
          <a:p>
            <a:endParaRPr lang="en-US" sz="4000" dirty="0">
              <a:solidFill>
                <a:srgbClr val="FFFFFF"/>
              </a:solidFill>
              <a:latin typeface="Calibri"/>
              <a:cs typeface="Calibri"/>
            </a:endParaRPr>
          </a:p>
          <a:p>
            <a:r>
              <a:rPr lang="en-US" sz="4000" dirty="0">
                <a:solidFill>
                  <a:srgbClr val="FFFFFF"/>
                </a:solidFill>
                <a:latin typeface="Calibri"/>
                <a:cs typeface="Calibri"/>
              </a:rPr>
              <a:t>A. 1 (Not confident)</a:t>
            </a:r>
          </a:p>
          <a:p>
            <a:r>
              <a:rPr lang="en-US" sz="4000" dirty="0">
                <a:solidFill>
                  <a:srgbClr val="FFFFFF"/>
                </a:solidFill>
                <a:latin typeface="Calibri"/>
                <a:cs typeface="Calibri"/>
              </a:rPr>
              <a:t>B. 2</a:t>
            </a:r>
            <a:endParaRPr lang="en-US" sz="4000" dirty="0">
              <a:solidFill>
                <a:srgbClr val="000000"/>
              </a:solidFill>
              <a:cs typeface="Calibri"/>
            </a:endParaRPr>
          </a:p>
          <a:p>
            <a:r>
              <a:rPr lang="en-US" sz="4000" dirty="0">
                <a:solidFill>
                  <a:srgbClr val="FFFFFF"/>
                </a:solidFill>
                <a:latin typeface="Calibri"/>
                <a:cs typeface="Calibri"/>
              </a:rPr>
              <a:t>C. 3</a:t>
            </a:r>
            <a:endParaRPr lang="en-US" sz="4000" dirty="0">
              <a:solidFill>
                <a:srgbClr val="000000"/>
              </a:solidFill>
              <a:cs typeface="Calibri"/>
            </a:endParaRPr>
          </a:p>
          <a:p>
            <a:r>
              <a:rPr lang="en-US" sz="4000" dirty="0">
                <a:solidFill>
                  <a:srgbClr val="FFFFFF"/>
                </a:solidFill>
                <a:latin typeface="Calibri"/>
                <a:cs typeface="Calibri"/>
              </a:rPr>
              <a:t>D. 4</a:t>
            </a:r>
            <a:endParaRPr lang="en-US" sz="4000" dirty="0">
              <a:solidFill>
                <a:srgbClr val="000000"/>
              </a:solidFill>
              <a:cs typeface="Calibri"/>
            </a:endParaRPr>
          </a:p>
          <a:p>
            <a:r>
              <a:rPr lang="en-US" sz="4000" dirty="0">
                <a:solidFill>
                  <a:srgbClr val="FFFFFF"/>
                </a:solidFill>
                <a:latin typeface="Calibri"/>
                <a:cs typeface="Calibri"/>
              </a:rPr>
              <a:t>E. 5 (Very confident)</a:t>
            </a:r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31340228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12" t="57948" r="26707" b="14033"/>
          <a:stretch/>
        </p:blipFill>
        <p:spPr>
          <a:xfrm>
            <a:off x="1141939" y="1471181"/>
            <a:ext cx="5238733" cy="349904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6C047E6-5EF2-45F4-AF6E-51BADE4C9A8E}"/>
              </a:ext>
            </a:extLst>
          </p:cNvPr>
          <p:cNvSpPr txBox="1"/>
          <p:nvPr/>
        </p:nvSpPr>
        <p:spPr>
          <a:xfrm>
            <a:off x="6808694" y="1541930"/>
            <a:ext cx="2743200" cy="31700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Q: Which cranial nerve nucleus is associated with the facial colliculus?​</a:t>
            </a: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A. V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B. VI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C. VII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D. VIII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E. I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60807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D7BC4EC-F2A0-46A5-A1B6-4AEF5079C8C4}"/>
              </a:ext>
            </a:extLst>
          </p:cNvPr>
          <p:cNvGrpSpPr/>
          <p:nvPr/>
        </p:nvGrpSpPr>
        <p:grpSpPr>
          <a:xfrm>
            <a:off x="1090955" y="692523"/>
            <a:ext cx="5860634" cy="4228551"/>
            <a:chOff x="2099484" y="457199"/>
            <a:chExt cx="8662104" cy="5976668"/>
          </a:xfrm>
        </p:grpSpPr>
        <p:pic>
          <p:nvPicPr>
            <p:cNvPr id="4" name="Content Placeholder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91" t="47170" r="16814" b="7646"/>
            <a:stretch/>
          </p:blipFill>
          <p:spPr bwMode="auto">
            <a:xfrm>
              <a:off x="2099484" y="457199"/>
              <a:ext cx="8662104" cy="59766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Oval 4"/>
            <p:cNvSpPr/>
            <p:nvPr/>
          </p:nvSpPr>
          <p:spPr>
            <a:xfrm rot="19218772">
              <a:off x="6924803" y="4328778"/>
              <a:ext cx="85792" cy="77693"/>
            </a:xfrm>
            <a:prstGeom prst="ellipse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" name="Oval 5"/>
            <p:cNvSpPr/>
            <p:nvPr/>
          </p:nvSpPr>
          <p:spPr>
            <a:xfrm rot="19218772">
              <a:off x="6864399" y="4438179"/>
              <a:ext cx="85792" cy="77693"/>
            </a:xfrm>
            <a:prstGeom prst="ellipse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7E63D460-A5C0-4091-A253-8EC8C128FF20}"/>
              </a:ext>
            </a:extLst>
          </p:cNvPr>
          <p:cNvSpPr txBox="1"/>
          <p:nvPr/>
        </p:nvSpPr>
        <p:spPr>
          <a:xfrm>
            <a:off x="7380194" y="1586753"/>
            <a:ext cx="3112994" cy="31700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Q: Which cranial nerve nucleus is indicated by the blue dots?​</a:t>
            </a: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A. VII</a:t>
            </a: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B. VIII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C. IX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D. X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E. X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41645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2" descr="Map&#10;&#10;Description automatically generated">
            <a:extLst>
              <a:ext uri="{FF2B5EF4-FFF2-40B4-BE49-F238E27FC236}">
                <a16:creationId xmlns:a16="http://schemas.microsoft.com/office/drawing/2014/main" id="{46A38785-F1EC-42FE-9609-621ED43640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2084" y="579534"/>
            <a:ext cx="5189621" cy="5364722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7E94C25-086C-42AD-AAD7-60E959420A9D}"/>
              </a:ext>
            </a:extLst>
          </p:cNvPr>
          <p:cNvSpPr txBox="1"/>
          <p:nvPr/>
        </p:nvSpPr>
        <p:spPr>
          <a:xfrm>
            <a:off x="6943165" y="1485900"/>
            <a:ext cx="3538817" cy="347787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Q: Which cranial nerve is most likely affected by this basilar artery aneurysm?​</a:t>
            </a: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A. I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B. II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C. III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D. IV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E. 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45367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050125" y="369364"/>
            <a:ext cx="3759200" cy="94679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851" dirty="0">
                <a:solidFill>
                  <a:schemeClr val="tx2"/>
                </a:solidFill>
              </a:rPr>
              <a:t>Magnified sagittal oblique through the internal auditory canal</a:t>
            </a:r>
            <a:endParaRPr lang="en-US" sz="1867" dirty="0">
              <a:solidFill>
                <a:schemeClr val="tx2"/>
              </a:solidFill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787556" y="1319364"/>
            <a:ext cx="11213705" cy="3581362"/>
            <a:chOff x="908178" y="2028291"/>
            <a:chExt cx="10674222" cy="3653604"/>
          </a:xfrm>
        </p:grpSpPr>
        <p:pic>
          <p:nvPicPr>
            <p:cNvPr id="5" name="Picture 3" descr="P:\Ho\cranial nerves sagittal 2.jpg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52" t="23889" r="30330" b="23687"/>
            <a:stretch/>
          </p:blipFill>
          <p:spPr bwMode="auto">
            <a:xfrm>
              <a:off x="7707085" y="2028291"/>
              <a:ext cx="3875315" cy="3653604"/>
            </a:xfrm>
            <a:prstGeom prst="rect">
              <a:avLst/>
            </a:prstGeom>
            <a:noFill/>
            <a:ln>
              <a:solidFill>
                <a:schemeClr val="tx2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" name="Group 5"/>
            <p:cNvGrpSpPr/>
            <p:nvPr/>
          </p:nvGrpSpPr>
          <p:grpSpPr>
            <a:xfrm>
              <a:off x="908178" y="2028291"/>
              <a:ext cx="6711823" cy="3568547"/>
              <a:chOff x="681133" y="1370823"/>
              <a:chExt cx="5033867" cy="2676410"/>
            </a:xfrm>
          </p:grpSpPr>
          <p:pic>
            <p:nvPicPr>
              <p:cNvPr id="8" name="Picture 2" descr="P:\Ho\cranial nerves sagittal.jpg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16" t="15978" r="7470" b="12487"/>
              <a:stretch/>
            </p:blipFill>
            <p:spPr bwMode="auto">
              <a:xfrm>
                <a:off x="681133" y="1975837"/>
                <a:ext cx="4581331" cy="207139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" name="Rectangle 8"/>
              <p:cNvSpPr/>
              <p:nvPr/>
            </p:nvSpPr>
            <p:spPr>
              <a:xfrm>
                <a:off x="2561175" y="2689041"/>
                <a:ext cx="762000" cy="741616"/>
              </a:xfrm>
              <a:prstGeom prst="rect">
                <a:avLst/>
              </a:prstGeom>
              <a:noFill/>
              <a:ln w="3175">
                <a:solidFill>
                  <a:schemeClr val="tx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cxnSp>
            <p:nvCxnSpPr>
              <p:cNvPr id="10" name="Straight Arrow Connector 9"/>
              <p:cNvCxnSpPr/>
              <p:nvPr/>
            </p:nvCxnSpPr>
            <p:spPr>
              <a:xfrm flipV="1">
                <a:off x="3323175" y="1370823"/>
                <a:ext cx="2391825" cy="1333275"/>
              </a:xfrm>
              <a:prstGeom prst="straightConnector1">
                <a:avLst/>
              </a:prstGeom>
              <a:ln>
                <a:solidFill>
                  <a:srgbClr val="FFC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Arrow Connector 10"/>
              <p:cNvCxnSpPr/>
              <p:nvPr/>
            </p:nvCxnSpPr>
            <p:spPr>
              <a:xfrm>
                <a:off x="3388488" y="3430657"/>
                <a:ext cx="2326512" cy="616576"/>
              </a:xfrm>
              <a:prstGeom prst="straightConnector1">
                <a:avLst/>
              </a:prstGeom>
              <a:ln>
                <a:solidFill>
                  <a:srgbClr val="FFC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6A72FFD3-BEFA-4E06-8837-52F99DB9AB0B}"/>
                </a:ext>
              </a:extLst>
            </p:cNvPr>
            <p:cNvCxnSpPr/>
            <p:nvPr/>
          </p:nvCxnSpPr>
          <p:spPr>
            <a:xfrm>
              <a:off x="8325853" y="3242510"/>
              <a:ext cx="1185110" cy="563480"/>
            </a:xfrm>
            <a:prstGeom prst="straightConnector1">
              <a:avLst/>
            </a:prstGeom>
            <a:ln w="57150">
              <a:solidFill>
                <a:srgbClr val="FFFF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6CC1FFF0-E292-483B-8F17-8980E2A38BF7}"/>
              </a:ext>
            </a:extLst>
          </p:cNvPr>
          <p:cNvSpPr txBox="1"/>
          <p:nvPr/>
        </p:nvSpPr>
        <p:spPr>
          <a:xfrm>
            <a:off x="791135" y="129988"/>
            <a:ext cx="3975847" cy="255454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Q: Which cranial nerve is indicated by the arrow?​</a:t>
            </a: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A.  Facial nerve</a:t>
            </a: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B. Cochlear nerve </a:t>
            </a: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C. Superior vestibular nerve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D. Inferior vestibular nerve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E. Glossopharyngeal nerv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10896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1CC816EA-190F-4849-B12B-E5C7697E9FCE}"/>
              </a:ext>
            </a:extLst>
          </p:cNvPr>
          <p:cNvGrpSpPr/>
          <p:nvPr/>
        </p:nvGrpSpPr>
        <p:grpSpPr>
          <a:xfrm>
            <a:off x="1046913" y="365426"/>
            <a:ext cx="7083371" cy="5290326"/>
            <a:chOff x="1897813" y="327326"/>
            <a:chExt cx="8394459" cy="619800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364FB47-7665-4F57-81AE-AD9A7756736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97813" y="2226829"/>
              <a:ext cx="5002113" cy="4298499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39884D49-BC3C-4F2F-9B0C-92C9B97C1BFF}"/>
                </a:ext>
              </a:extLst>
            </p:cNvPr>
            <p:cNvSpPr/>
            <p:nvPr/>
          </p:nvSpPr>
          <p:spPr>
            <a:xfrm>
              <a:off x="3447392" y="3557199"/>
              <a:ext cx="1902958" cy="1637760"/>
            </a:xfrm>
            <a:prstGeom prst="rect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E374822A-926B-46F1-BC5F-8E5F2AB52C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366906" y="327326"/>
              <a:ext cx="3925366" cy="3404317"/>
            </a:xfrm>
            <a:prstGeom prst="rect">
              <a:avLst/>
            </a:prstGeom>
          </p:spPr>
        </p:pic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700EB373-491A-46B7-BE78-655CBC8DA2F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50350" y="3731643"/>
              <a:ext cx="4941922" cy="1462638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E6D9890F-5367-4EF0-AB21-698C0046116E}"/>
                </a:ext>
              </a:extLst>
            </p:cNvPr>
            <p:cNvCxnSpPr/>
            <p:nvPr/>
          </p:nvCxnSpPr>
          <p:spPr>
            <a:xfrm flipH="1">
              <a:off x="9061617" y="1763707"/>
              <a:ext cx="732290" cy="248105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AEB2DB0D-A458-4300-9979-F8E057C67BEA}"/>
                </a:ext>
              </a:extLst>
            </p:cNvPr>
            <p:cNvCxnSpPr/>
            <p:nvPr/>
          </p:nvCxnSpPr>
          <p:spPr>
            <a:xfrm flipV="1">
              <a:off x="3447393" y="327326"/>
              <a:ext cx="2919513" cy="3229874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B57B2748-5C8E-4FFA-B2C7-010B6A607695}"/>
              </a:ext>
            </a:extLst>
          </p:cNvPr>
          <p:cNvSpPr txBox="1"/>
          <p:nvPr/>
        </p:nvSpPr>
        <p:spPr>
          <a:xfrm>
            <a:off x="8318500" y="1536700"/>
            <a:ext cx="3352800" cy="31700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Q: Which cranial nerve does not have roots arising from the postolivary sulcus of the medulla (blue arrow)? ​</a:t>
            </a: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A. Glossopharyngeal</a:t>
            </a: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B. Vagus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C. Spinal accessory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D. Hypoglossal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E. C and 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40286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83085" y="406160"/>
            <a:ext cx="4754481" cy="3198474"/>
            <a:chOff x="2438500" y="2798763"/>
            <a:chExt cx="3860700" cy="3095625"/>
          </a:xfrm>
        </p:grpSpPr>
        <p:pic>
          <p:nvPicPr>
            <p:cNvPr id="4" name="Shape 302"/>
            <p:cNvPicPr preferRelativeResize="0"/>
            <p:nvPr/>
          </p:nvPicPr>
          <p:blipFill rotWithShape="1">
            <a:blip r:embed="rId3">
              <a:alphaModFix/>
            </a:blip>
            <a:srcRect b="31135"/>
            <a:stretch/>
          </p:blipFill>
          <p:spPr>
            <a:xfrm>
              <a:off x="2438500" y="2798763"/>
              <a:ext cx="3860700" cy="3095625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5" name="Shape 303"/>
            <p:cNvCxnSpPr/>
            <p:nvPr/>
          </p:nvCxnSpPr>
          <p:spPr>
            <a:xfrm flipV="1">
              <a:off x="3302619" y="4273277"/>
              <a:ext cx="695222" cy="354286"/>
            </a:xfrm>
            <a:prstGeom prst="straightConnector1">
              <a:avLst/>
            </a:prstGeom>
            <a:noFill/>
            <a:ln w="44450" cap="flat" cmpd="sng">
              <a:solidFill>
                <a:srgbClr val="0070C0"/>
              </a:solidFill>
              <a:prstDash val="solid"/>
              <a:miter/>
              <a:headEnd type="none" w="med" len="med"/>
              <a:tailEnd type="triangle" w="lg" len="lg"/>
            </a:ln>
          </p:spPr>
        </p:cxnSp>
      </p:grpSp>
      <p:grpSp>
        <p:nvGrpSpPr>
          <p:cNvPr id="6" name="Group 5"/>
          <p:cNvGrpSpPr/>
          <p:nvPr/>
        </p:nvGrpSpPr>
        <p:grpSpPr>
          <a:xfrm>
            <a:off x="1000019" y="3600222"/>
            <a:ext cx="4529828" cy="3075784"/>
            <a:chOff x="6299200" y="1905000"/>
            <a:chExt cx="5745211" cy="4114200"/>
          </a:xfrm>
        </p:grpSpPr>
        <p:pic>
          <p:nvPicPr>
            <p:cNvPr id="7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73" t="26562" r="17186" b="25000"/>
            <a:stretch/>
          </p:blipFill>
          <p:spPr bwMode="auto">
            <a:xfrm>
              <a:off x="6299200" y="1905000"/>
              <a:ext cx="5745211" cy="4114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8" name="Shape 303"/>
            <p:cNvCxnSpPr/>
            <p:nvPr/>
          </p:nvCxnSpPr>
          <p:spPr>
            <a:xfrm flipV="1">
              <a:off x="7562850" y="4445000"/>
              <a:ext cx="697051" cy="136525"/>
            </a:xfrm>
            <a:prstGeom prst="straightConnector1">
              <a:avLst/>
            </a:prstGeom>
            <a:noFill/>
            <a:ln w="44450" cap="flat" cmpd="sng">
              <a:solidFill>
                <a:srgbClr val="0070C0"/>
              </a:solidFill>
              <a:prstDash val="solid"/>
              <a:miter/>
              <a:headEnd type="none" w="med" len="med"/>
              <a:tailEnd type="triangle" w="lg" len="lg"/>
            </a:ln>
          </p:spPr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39B5CF9B-1CA7-4C41-9B2C-E843D0545E70}"/>
              </a:ext>
            </a:extLst>
          </p:cNvPr>
          <p:cNvSpPr txBox="1"/>
          <p:nvPr/>
        </p:nvSpPr>
        <p:spPr>
          <a:xfrm>
            <a:off x="6578600" y="1587500"/>
            <a:ext cx="2743200" cy="31700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Q: Which nerve does not exit through the foramen indicated by the blue arrows?​</a:t>
            </a: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A. III</a:t>
            </a: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B. IV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C. V1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D. V2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E. V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265682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334BEC2-5FD2-43CE-9476-C224CBE228D5}"/>
              </a:ext>
            </a:extLst>
          </p:cNvPr>
          <p:cNvGrpSpPr/>
          <p:nvPr/>
        </p:nvGrpSpPr>
        <p:grpSpPr>
          <a:xfrm>
            <a:off x="855158" y="67539"/>
            <a:ext cx="4575267" cy="2568865"/>
            <a:chOff x="664658" y="1858239"/>
            <a:chExt cx="6480267" cy="3432465"/>
          </a:xfrm>
        </p:grpSpPr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83" t="17037" r="25833" b="41481"/>
            <a:stretch/>
          </p:blipFill>
          <p:spPr bwMode="auto">
            <a:xfrm>
              <a:off x="664658" y="1858239"/>
              <a:ext cx="6480267" cy="3432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6" name="Straight Arrow Connector 5"/>
            <p:cNvCxnSpPr/>
            <p:nvPr/>
          </p:nvCxnSpPr>
          <p:spPr>
            <a:xfrm flipH="1" flipV="1">
              <a:off x="5062924" y="3755050"/>
              <a:ext cx="777055" cy="1032174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B6C9A45C-E0CB-43E1-8B1B-7E42D06A82D7}"/>
              </a:ext>
            </a:extLst>
          </p:cNvPr>
          <p:cNvGrpSpPr/>
          <p:nvPr/>
        </p:nvGrpSpPr>
        <p:grpSpPr>
          <a:xfrm>
            <a:off x="1534937" y="2704143"/>
            <a:ext cx="3227563" cy="4023941"/>
            <a:chOff x="7161037" y="227643"/>
            <a:chExt cx="5030963" cy="5916241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78" t="20624" r="62405" b="19063"/>
            <a:stretch/>
          </p:blipFill>
          <p:spPr bwMode="auto">
            <a:xfrm>
              <a:off x="7161037" y="227643"/>
              <a:ext cx="5030963" cy="59162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9" name="Straight Arrow Connector 8"/>
            <p:cNvCxnSpPr/>
            <p:nvPr/>
          </p:nvCxnSpPr>
          <p:spPr>
            <a:xfrm>
              <a:off x="8505645" y="1731513"/>
              <a:ext cx="711200" cy="1524000"/>
            </a:xfrm>
            <a:prstGeom prst="straightConnector1">
              <a:avLst/>
            </a:prstGeom>
            <a:ln w="12700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84589B19-DE62-4673-9EC3-05F093481156}"/>
              </a:ext>
            </a:extLst>
          </p:cNvPr>
          <p:cNvSpPr txBox="1"/>
          <p:nvPr/>
        </p:nvSpPr>
        <p:spPr>
          <a:xfrm>
            <a:off x="7277100" y="1600200"/>
            <a:ext cx="4000500" cy="31700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Q: Which cranial nerve exits the foramen indicated by the yellow arrow?​</a:t>
            </a: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endParaRPr lang="en-US" sz="2000" dirty="0">
              <a:solidFill>
                <a:srgbClr val="FFFFFF"/>
              </a:solidFill>
              <a:latin typeface="Calibri"/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A. Glossopharyngeal nerve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C. Maxillary division of CN V 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D. Mandibular division of CN V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E. Hypoglossal nerve</a:t>
            </a:r>
            <a:endParaRPr lang="en-US" dirty="0">
              <a:solidFill>
                <a:srgbClr val="000000"/>
              </a:solidFill>
              <a:cs typeface="Calibri"/>
            </a:endParaRPr>
          </a:p>
          <a:p>
            <a:r>
              <a:rPr lang="en-US" sz="2000" dirty="0">
                <a:solidFill>
                  <a:srgbClr val="FFFFFF"/>
                </a:solidFill>
                <a:latin typeface="Calibri"/>
                <a:cs typeface="Calibri"/>
              </a:rPr>
              <a:t>F. Vagus nerv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665645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15FCE9A-746E-41C2-87A5-669FF45D68F0}"/>
              </a:ext>
            </a:extLst>
          </p:cNvPr>
          <p:cNvSpPr txBox="1"/>
          <p:nvPr/>
        </p:nvSpPr>
        <p:spPr>
          <a:xfrm>
            <a:off x="4724400" y="3200400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Click to add text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227FA05-B82C-443B-A0C7-2873C535026F}"/>
              </a:ext>
            </a:extLst>
          </p:cNvPr>
          <p:cNvSpPr txBox="1"/>
          <p:nvPr/>
        </p:nvSpPr>
        <p:spPr>
          <a:xfrm>
            <a:off x="1116106" y="903194"/>
            <a:ext cx="10441641" cy="144655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4400" dirty="0">
                <a:solidFill>
                  <a:srgbClr val="FFFFFF"/>
                </a:solidFill>
                <a:latin typeface="Calibri"/>
              </a:rPr>
              <a:t>Q: Which cranial nerve is not associated with the lateral dural wall of the cavernous sinus?</a:t>
            </a:r>
            <a:endParaRPr lang="en-US" sz="4400" dirty="0">
              <a:solidFill>
                <a:srgbClr val="FFFFFF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F11CC29-7C70-48DF-AE43-929623253D36}"/>
              </a:ext>
            </a:extLst>
          </p:cNvPr>
          <p:cNvSpPr txBox="1"/>
          <p:nvPr/>
        </p:nvSpPr>
        <p:spPr>
          <a:xfrm>
            <a:off x="1117600" y="3124200"/>
            <a:ext cx="7353300" cy="347787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4400" dirty="0">
                <a:solidFill>
                  <a:srgbClr val="FFFFFF"/>
                </a:solidFill>
                <a:latin typeface="Calibri"/>
              </a:rPr>
              <a:t>A. III</a:t>
            </a:r>
            <a:endParaRPr lang="en-US" sz="4400" dirty="0">
              <a:solidFill>
                <a:srgbClr val="FFFFFF"/>
              </a:solidFill>
            </a:endParaRPr>
          </a:p>
          <a:p>
            <a:r>
              <a:rPr lang="en-US" sz="4400" dirty="0">
                <a:solidFill>
                  <a:srgbClr val="FFFFFF"/>
                </a:solidFill>
                <a:latin typeface="Calibri"/>
              </a:rPr>
              <a:t>B. IV</a:t>
            </a:r>
            <a:endParaRPr lang="en-US" sz="4400" dirty="0">
              <a:solidFill>
                <a:srgbClr val="FFFFFF"/>
              </a:solidFill>
            </a:endParaRPr>
          </a:p>
          <a:p>
            <a:r>
              <a:rPr lang="en-US" sz="4400" dirty="0">
                <a:solidFill>
                  <a:srgbClr val="FFFFFF"/>
                </a:solidFill>
                <a:latin typeface="Calibri"/>
              </a:rPr>
              <a:t>C. Ophthalmic division V</a:t>
            </a:r>
            <a:endParaRPr lang="en-US" sz="4400" dirty="0">
              <a:solidFill>
                <a:srgbClr val="FFFFFF"/>
              </a:solidFill>
            </a:endParaRPr>
          </a:p>
          <a:p>
            <a:r>
              <a:rPr lang="en-US" sz="4400" dirty="0">
                <a:solidFill>
                  <a:srgbClr val="FFFFFF"/>
                </a:solidFill>
                <a:latin typeface="Calibri"/>
              </a:rPr>
              <a:t>D. Maxillary division of V</a:t>
            </a:r>
            <a:endParaRPr lang="en-US" sz="4400" dirty="0">
              <a:solidFill>
                <a:srgbClr val="FFFFFF"/>
              </a:solidFill>
            </a:endParaRPr>
          </a:p>
          <a:p>
            <a:r>
              <a:rPr lang="en-US" sz="4400" dirty="0">
                <a:solidFill>
                  <a:srgbClr val="FFFFFF"/>
                </a:solidFill>
                <a:latin typeface="Calibri"/>
              </a:rPr>
              <a:t>E. VI</a:t>
            </a:r>
            <a:endParaRPr lang="en-US" sz="44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1425955"/>
      </p:ext>
    </p:extLst>
  </p:cSld>
  <p:clrMapOvr>
    <a:masterClrMapping/>
  </p:clrMapOvr>
</p:sld>
</file>

<file path=ppt/theme/theme1.xml><?xml version="1.0" encoding="utf-8"?>
<a:theme xmlns:a="http://schemas.openxmlformats.org/drawingml/2006/main" name="PowerPoint Theme  - WFSOM">
  <a:themeElements>
    <a:clrScheme name="EL 14">
      <a:dk1>
        <a:srgbClr val="000000"/>
      </a:dk1>
      <a:lt1>
        <a:srgbClr val="000000"/>
      </a:lt1>
      <a:dk2>
        <a:srgbClr val="CC9900"/>
      </a:dk2>
      <a:lt2>
        <a:srgbClr val="969696"/>
      </a:lt2>
      <a:accent1>
        <a:srgbClr val="FFF0C8"/>
      </a:accent1>
      <a:accent2>
        <a:srgbClr val="669900"/>
      </a:accent2>
      <a:accent3>
        <a:srgbClr val="AAAAAA"/>
      </a:accent3>
      <a:accent4>
        <a:srgbClr val="000000"/>
      </a:accent4>
      <a:accent5>
        <a:srgbClr val="FFF6E0"/>
      </a:accent5>
      <a:accent6>
        <a:srgbClr val="5C8A00"/>
      </a:accent6>
      <a:hlink>
        <a:srgbClr val="990033"/>
      </a:hlink>
      <a:folHlink>
        <a:srgbClr val="660066"/>
      </a:folHlink>
    </a:clrScheme>
    <a:fontScheme name="EL">
      <a:majorFont>
        <a:latin typeface="Trebuchet MS"/>
        <a:ea typeface=""/>
        <a:cs typeface=""/>
      </a:majorFont>
      <a:minorFont>
        <a:latin typeface="Trebuchet M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EL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3">
        <a:dk1>
          <a:srgbClr val="000000"/>
        </a:dk1>
        <a:lt1>
          <a:srgbClr val="FFF0C8"/>
        </a:lt1>
        <a:dk2>
          <a:srgbClr val="000000"/>
        </a:dk2>
        <a:lt2>
          <a:srgbClr val="969696"/>
        </a:lt2>
        <a:accent1>
          <a:srgbClr val="CC9900"/>
        </a:accent1>
        <a:accent2>
          <a:srgbClr val="669900"/>
        </a:accent2>
        <a:accent3>
          <a:srgbClr val="FFF6E0"/>
        </a:accent3>
        <a:accent4>
          <a:srgbClr val="000000"/>
        </a:accent4>
        <a:accent5>
          <a:srgbClr val="E2CAAA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14">
        <a:dk1>
          <a:srgbClr val="000000"/>
        </a:dk1>
        <a:lt1>
          <a:srgbClr val="000000"/>
        </a:lt1>
        <a:dk2>
          <a:srgbClr val="CC9900"/>
        </a:dk2>
        <a:lt2>
          <a:srgbClr val="969696"/>
        </a:lt2>
        <a:accent1>
          <a:srgbClr val="FFF0C8"/>
        </a:accent1>
        <a:accent2>
          <a:srgbClr val="669900"/>
        </a:accent2>
        <a:accent3>
          <a:srgbClr val="AAAAAA"/>
        </a:accent3>
        <a:accent4>
          <a:srgbClr val="000000"/>
        </a:accent4>
        <a:accent5>
          <a:srgbClr val="FFF6E0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Default Design">
  <a:themeElements>
    <a:clrScheme name="Default Design 14">
      <a:dk1>
        <a:srgbClr val="000000"/>
      </a:dk1>
      <a:lt1>
        <a:srgbClr val="000000"/>
      </a:lt1>
      <a:dk2>
        <a:srgbClr val="CC9900"/>
      </a:dk2>
      <a:lt2>
        <a:srgbClr val="969696"/>
      </a:lt2>
      <a:accent1>
        <a:srgbClr val="FFF0C8"/>
      </a:accent1>
      <a:accent2>
        <a:srgbClr val="669900"/>
      </a:accent2>
      <a:accent3>
        <a:srgbClr val="AAAAAA"/>
      </a:accent3>
      <a:accent4>
        <a:srgbClr val="000000"/>
      </a:accent4>
      <a:accent5>
        <a:srgbClr val="FFF6E0"/>
      </a:accent5>
      <a:accent6>
        <a:srgbClr val="5C8A00"/>
      </a:accent6>
      <a:hlink>
        <a:srgbClr val="990033"/>
      </a:hlink>
      <a:folHlink>
        <a:srgbClr val="660066"/>
      </a:folHlink>
    </a:clrScheme>
    <a:fontScheme name="Default Design">
      <a:majorFont>
        <a:latin typeface="Trebuchet MS"/>
        <a:ea typeface=""/>
        <a:cs typeface=""/>
      </a:majorFont>
      <a:minorFont>
        <a:latin typeface="Trebuchet M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3">
        <a:dk1>
          <a:srgbClr val="000000"/>
        </a:dk1>
        <a:lt1>
          <a:srgbClr val="FFF0C8"/>
        </a:lt1>
        <a:dk2>
          <a:srgbClr val="000000"/>
        </a:dk2>
        <a:lt2>
          <a:srgbClr val="969696"/>
        </a:lt2>
        <a:accent1>
          <a:srgbClr val="CC9900"/>
        </a:accent1>
        <a:accent2>
          <a:srgbClr val="669900"/>
        </a:accent2>
        <a:accent3>
          <a:srgbClr val="FFF6E0"/>
        </a:accent3>
        <a:accent4>
          <a:srgbClr val="000000"/>
        </a:accent4>
        <a:accent5>
          <a:srgbClr val="E2CAAA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14">
        <a:dk1>
          <a:srgbClr val="000000"/>
        </a:dk1>
        <a:lt1>
          <a:srgbClr val="000000"/>
        </a:lt1>
        <a:dk2>
          <a:srgbClr val="CC9900"/>
        </a:dk2>
        <a:lt2>
          <a:srgbClr val="969696"/>
        </a:lt2>
        <a:accent1>
          <a:srgbClr val="FFF0C8"/>
        </a:accent1>
        <a:accent2>
          <a:srgbClr val="669900"/>
        </a:accent2>
        <a:accent3>
          <a:srgbClr val="AAAAAA"/>
        </a:accent3>
        <a:accent4>
          <a:srgbClr val="000000"/>
        </a:accent4>
        <a:accent5>
          <a:srgbClr val="FFF6E0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1_Default Design">
  <a:themeElements>
    <a:clrScheme name="1_Default Design 14">
      <a:dk1>
        <a:srgbClr val="000000"/>
      </a:dk1>
      <a:lt1>
        <a:srgbClr val="000000"/>
      </a:lt1>
      <a:dk2>
        <a:srgbClr val="CC9900"/>
      </a:dk2>
      <a:lt2>
        <a:srgbClr val="969696"/>
      </a:lt2>
      <a:accent1>
        <a:srgbClr val="FFF0C8"/>
      </a:accent1>
      <a:accent2>
        <a:srgbClr val="669900"/>
      </a:accent2>
      <a:accent3>
        <a:srgbClr val="AAAAAA"/>
      </a:accent3>
      <a:accent4>
        <a:srgbClr val="000000"/>
      </a:accent4>
      <a:accent5>
        <a:srgbClr val="FFF6E0"/>
      </a:accent5>
      <a:accent6>
        <a:srgbClr val="5C8A00"/>
      </a:accent6>
      <a:hlink>
        <a:srgbClr val="990033"/>
      </a:hlink>
      <a:folHlink>
        <a:srgbClr val="660066"/>
      </a:folHlink>
    </a:clrScheme>
    <a:fontScheme name="1_Default Design">
      <a:majorFont>
        <a:latin typeface="Trebuchet MS"/>
        <a:ea typeface=""/>
        <a:cs typeface=""/>
      </a:majorFont>
      <a:minorFont>
        <a:latin typeface="Trebuchet M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1_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13">
        <a:dk1>
          <a:srgbClr val="000000"/>
        </a:dk1>
        <a:lt1>
          <a:srgbClr val="FFF0C8"/>
        </a:lt1>
        <a:dk2>
          <a:srgbClr val="000000"/>
        </a:dk2>
        <a:lt2>
          <a:srgbClr val="969696"/>
        </a:lt2>
        <a:accent1>
          <a:srgbClr val="CC9900"/>
        </a:accent1>
        <a:accent2>
          <a:srgbClr val="669900"/>
        </a:accent2>
        <a:accent3>
          <a:srgbClr val="FFF6E0"/>
        </a:accent3>
        <a:accent4>
          <a:srgbClr val="000000"/>
        </a:accent4>
        <a:accent5>
          <a:srgbClr val="E2CAAA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14">
        <a:dk1>
          <a:srgbClr val="000000"/>
        </a:dk1>
        <a:lt1>
          <a:srgbClr val="000000"/>
        </a:lt1>
        <a:dk2>
          <a:srgbClr val="CC9900"/>
        </a:dk2>
        <a:lt2>
          <a:srgbClr val="969696"/>
        </a:lt2>
        <a:accent1>
          <a:srgbClr val="FFF0C8"/>
        </a:accent1>
        <a:accent2>
          <a:srgbClr val="669900"/>
        </a:accent2>
        <a:accent3>
          <a:srgbClr val="AAAAAA"/>
        </a:accent3>
        <a:accent4>
          <a:srgbClr val="000000"/>
        </a:accent4>
        <a:accent5>
          <a:srgbClr val="FFF6E0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Wake Forest Baptist Health PPT Theme">
  <a:themeElements>
    <a:clrScheme name="Lacks WakeHealth">
      <a:dk1>
        <a:srgbClr val="000000"/>
      </a:dk1>
      <a:lt1>
        <a:srgbClr val="000000"/>
      </a:lt1>
      <a:dk2>
        <a:srgbClr val="CC9900"/>
      </a:dk2>
      <a:lt2>
        <a:srgbClr val="969696"/>
      </a:lt2>
      <a:accent1>
        <a:srgbClr val="FFF0C8"/>
      </a:accent1>
      <a:accent2>
        <a:srgbClr val="669900"/>
      </a:accent2>
      <a:accent3>
        <a:srgbClr val="AAAAAA"/>
      </a:accent3>
      <a:accent4>
        <a:srgbClr val="000000"/>
      </a:accent4>
      <a:accent5>
        <a:srgbClr val="FFF6E0"/>
      </a:accent5>
      <a:accent6>
        <a:srgbClr val="5C8A00"/>
      </a:accent6>
      <a:hlink>
        <a:srgbClr val="990033"/>
      </a:hlink>
      <a:folHlink>
        <a:srgbClr val="660066"/>
      </a:folHlink>
    </a:clrScheme>
    <a:fontScheme name="EL">
      <a:majorFont>
        <a:latin typeface="Trebuchet MS"/>
        <a:ea typeface=""/>
        <a:cs typeface=""/>
      </a:majorFont>
      <a:minorFont>
        <a:latin typeface="Trebuchet M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EL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3">
        <a:dk1>
          <a:srgbClr val="000000"/>
        </a:dk1>
        <a:lt1>
          <a:srgbClr val="FFF0C8"/>
        </a:lt1>
        <a:dk2>
          <a:srgbClr val="000000"/>
        </a:dk2>
        <a:lt2>
          <a:srgbClr val="969696"/>
        </a:lt2>
        <a:accent1>
          <a:srgbClr val="CC9900"/>
        </a:accent1>
        <a:accent2>
          <a:srgbClr val="669900"/>
        </a:accent2>
        <a:accent3>
          <a:srgbClr val="FFF6E0"/>
        </a:accent3>
        <a:accent4>
          <a:srgbClr val="000000"/>
        </a:accent4>
        <a:accent5>
          <a:srgbClr val="E2CAAA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14">
        <a:dk1>
          <a:srgbClr val="000000"/>
        </a:dk1>
        <a:lt1>
          <a:srgbClr val="000000"/>
        </a:lt1>
        <a:dk2>
          <a:srgbClr val="CC9900"/>
        </a:dk2>
        <a:lt2>
          <a:srgbClr val="969696"/>
        </a:lt2>
        <a:accent1>
          <a:srgbClr val="FFF0C8"/>
        </a:accent1>
        <a:accent2>
          <a:srgbClr val="669900"/>
        </a:accent2>
        <a:accent3>
          <a:srgbClr val="AAAAAA"/>
        </a:accent3>
        <a:accent4>
          <a:srgbClr val="000000"/>
        </a:accent4>
        <a:accent5>
          <a:srgbClr val="FFF6E0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2_Default Design">
  <a:themeElements>
    <a:clrScheme name="Lacks WakeHealth">
      <a:dk1>
        <a:srgbClr val="000000"/>
      </a:dk1>
      <a:lt1>
        <a:srgbClr val="000000"/>
      </a:lt1>
      <a:dk2>
        <a:srgbClr val="CC9900"/>
      </a:dk2>
      <a:lt2>
        <a:srgbClr val="969696"/>
      </a:lt2>
      <a:accent1>
        <a:srgbClr val="FFF0C8"/>
      </a:accent1>
      <a:accent2>
        <a:srgbClr val="669900"/>
      </a:accent2>
      <a:accent3>
        <a:srgbClr val="AAAAAA"/>
      </a:accent3>
      <a:accent4>
        <a:srgbClr val="000000"/>
      </a:accent4>
      <a:accent5>
        <a:srgbClr val="FFF6E0"/>
      </a:accent5>
      <a:accent6>
        <a:srgbClr val="5C8A00"/>
      </a:accent6>
      <a:hlink>
        <a:srgbClr val="990033"/>
      </a:hlink>
      <a:folHlink>
        <a:srgbClr val="660066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3">
        <a:dk1>
          <a:srgbClr val="000000"/>
        </a:dk1>
        <a:lt1>
          <a:srgbClr val="FFF0C8"/>
        </a:lt1>
        <a:dk2>
          <a:srgbClr val="000000"/>
        </a:dk2>
        <a:lt2>
          <a:srgbClr val="969696"/>
        </a:lt2>
        <a:accent1>
          <a:srgbClr val="CC9900"/>
        </a:accent1>
        <a:accent2>
          <a:srgbClr val="669900"/>
        </a:accent2>
        <a:accent3>
          <a:srgbClr val="FFF6E0"/>
        </a:accent3>
        <a:accent4>
          <a:srgbClr val="000000"/>
        </a:accent4>
        <a:accent5>
          <a:srgbClr val="E2CAAA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14">
        <a:dk1>
          <a:srgbClr val="000000"/>
        </a:dk1>
        <a:lt1>
          <a:srgbClr val="000000"/>
        </a:lt1>
        <a:dk2>
          <a:srgbClr val="CC9900"/>
        </a:dk2>
        <a:lt2>
          <a:srgbClr val="969696"/>
        </a:lt2>
        <a:accent1>
          <a:srgbClr val="FFF0C8"/>
        </a:accent1>
        <a:accent2>
          <a:srgbClr val="669900"/>
        </a:accent2>
        <a:accent3>
          <a:srgbClr val="AAAAAA"/>
        </a:accent3>
        <a:accent4>
          <a:srgbClr val="000000"/>
        </a:accent4>
        <a:accent5>
          <a:srgbClr val="FFF6E0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6.xml><?xml version="1.0" encoding="utf-8"?>
<a:theme xmlns:a="http://schemas.openxmlformats.org/drawingml/2006/main" name="3_Default Design">
  <a:themeElements>
    <a:clrScheme name="1_Default Design 14">
      <a:dk1>
        <a:srgbClr val="000000"/>
      </a:dk1>
      <a:lt1>
        <a:srgbClr val="000000"/>
      </a:lt1>
      <a:dk2>
        <a:srgbClr val="CC9900"/>
      </a:dk2>
      <a:lt2>
        <a:srgbClr val="969696"/>
      </a:lt2>
      <a:accent1>
        <a:srgbClr val="FFF0C8"/>
      </a:accent1>
      <a:accent2>
        <a:srgbClr val="669900"/>
      </a:accent2>
      <a:accent3>
        <a:srgbClr val="AAAAAA"/>
      </a:accent3>
      <a:accent4>
        <a:srgbClr val="000000"/>
      </a:accent4>
      <a:accent5>
        <a:srgbClr val="FFF6E0"/>
      </a:accent5>
      <a:accent6>
        <a:srgbClr val="5C8A00"/>
      </a:accent6>
      <a:hlink>
        <a:srgbClr val="990033"/>
      </a:hlink>
      <a:folHlink>
        <a:srgbClr val="660066"/>
      </a:folHlink>
    </a:clrScheme>
    <a:fontScheme name="1_Default Design">
      <a:majorFont>
        <a:latin typeface="Trebuchet MS"/>
        <a:ea typeface=""/>
        <a:cs typeface=""/>
      </a:majorFont>
      <a:minorFont>
        <a:latin typeface="Trebuchet M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1_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Default Design 13">
        <a:dk1>
          <a:srgbClr val="000000"/>
        </a:dk1>
        <a:lt1>
          <a:srgbClr val="FFF0C8"/>
        </a:lt1>
        <a:dk2>
          <a:srgbClr val="000000"/>
        </a:dk2>
        <a:lt2>
          <a:srgbClr val="969696"/>
        </a:lt2>
        <a:accent1>
          <a:srgbClr val="CC9900"/>
        </a:accent1>
        <a:accent2>
          <a:srgbClr val="669900"/>
        </a:accent2>
        <a:accent3>
          <a:srgbClr val="FFF6E0"/>
        </a:accent3>
        <a:accent4>
          <a:srgbClr val="000000"/>
        </a:accent4>
        <a:accent5>
          <a:srgbClr val="E2CAAA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Default Design 14">
        <a:dk1>
          <a:srgbClr val="000000"/>
        </a:dk1>
        <a:lt1>
          <a:srgbClr val="000000"/>
        </a:lt1>
        <a:dk2>
          <a:srgbClr val="CC9900"/>
        </a:dk2>
        <a:lt2>
          <a:srgbClr val="969696"/>
        </a:lt2>
        <a:accent1>
          <a:srgbClr val="FFF0C8"/>
        </a:accent1>
        <a:accent2>
          <a:srgbClr val="669900"/>
        </a:accent2>
        <a:accent3>
          <a:srgbClr val="AAAAAA"/>
        </a:accent3>
        <a:accent4>
          <a:srgbClr val="000000"/>
        </a:accent4>
        <a:accent5>
          <a:srgbClr val="FFF6E0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7.xml><?xml version="1.0" encoding="utf-8"?>
<a:theme xmlns:a="http://schemas.openxmlformats.org/drawingml/2006/main" name="1_PowerPoint Theme  - WFSOM">
  <a:themeElements>
    <a:clrScheme name="EL 14">
      <a:dk1>
        <a:srgbClr val="000000"/>
      </a:dk1>
      <a:lt1>
        <a:srgbClr val="000000"/>
      </a:lt1>
      <a:dk2>
        <a:srgbClr val="CC9900"/>
      </a:dk2>
      <a:lt2>
        <a:srgbClr val="969696"/>
      </a:lt2>
      <a:accent1>
        <a:srgbClr val="FFF0C8"/>
      </a:accent1>
      <a:accent2>
        <a:srgbClr val="669900"/>
      </a:accent2>
      <a:accent3>
        <a:srgbClr val="AAAAAA"/>
      </a:accent3>
      <a:accent4>
        <a:srgbClr val="000000"/>
      </a:accent4>
      <a:accent5>
        <a:srgbClr val="FFF6E0"/>
      </a:accent5>
      <a:accent6>
        <a:srgbClr val="5C8A00"/>
      </a:accent6>
      <a:hlink>
        <a:srgbClr val="990033"/>
      </a:hlink>
      <a:folHlink>
        <a:srgbClr val="660066"/>
      </a:folHlink>
    </a:clrScheme>
    <a:fontScheme name="EL">
      <a:majorFont>
        <a:latin typeface="Trebuchet MS"/>
        <a:ea typeface=""/>
        <a:cs typeface=""/>
      </a:majorFont>
      <a:minorFont>
        <a:latin typeface="Trebuchet M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EL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L 13">
        <a:dk1>
          <a:srgbClr val="000000"/>
        </a:dk1>
        <a:lt1>
          <a:srgbClr val="FFF0C8"/>
        </a:lt1>
        <a:dk2>
          <a:srgbClr val="000000"/>
        </a:dk2>
        <a:lt2>
          <a:srgbClr val="969696"/>
        </a:lt2>
        <a:accent1>
          <a:srgbClr val="CC9900"/>
        </a:accent1>
        <a:accent2>
          <a:srgbClr val="669900"/>
        </a:accent2>
        <a:accent3>
          <a:srgbClr val="FFF6E0"/>
        </a:accent3>
        <a:accent4>
          <a:srgbClr val="000000"/>
        </a:accent4>
        <a:accent5>
          <a:srgbClr val="E2CAAA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L 14">
        <a:dk1>
          <a:srgbClr val="000000"/>
        </a:dk1>
        <a:lt1>
          <a:srgbClr val="000000"/>
        </a:lt1>
        <a:dk2>
          <a:srgbClr val="CC9900"/>
        </a:dk2>
        <a:lt2>
          <a:srgbClr val="969696"/>
        </a:lt2>
        <a:accent1>
          <a:srgbClr val="FFF0C8"/>
        </a:accent1>
        <a:accent2>
          <a:srgbClr val="669900"/>
        </a:accent2>
        <a:accent3>
          <a:srgbClr val="AAAAAA"/>
        </a:accent3>
        <a:accent4>
          <a:srgbClr val="000000"/>
        </a:accent4>
        <a:accent5>
          <a:srgbClr val="FFF6E0"/>
        </a:accent5>
        <a:accent6>
          <a:srgbClr val="5C8A00"/>
        </a:accent6>
        <a:hlink>
          <a:srgbClr val="990033"/>
        </a:hlink>
        <a:folHlink>
          <a:srgbClr val="660066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ACC25D49F2F4B4489B9721A466FDF4D" ma:contentTypeVersion="8" ma:contentTypeDescription="Create a new document." ma:contentTypeScope="" ma:versionID="71e9c98e0f852595cf47c6f661845709">
  <xsd:schema xmlns:xsd="http://www.w3.org/2001/XMLSchema" xmlns:xs="http://www.w3.org/2001/XMLSchema" xmlns:p="http://schemas.microsoft.com/office/2006/metadata/properties" xmlns:ns2="8fddeaa3-4732-4488-9db6-a053d8348361" xmlns:ns3="1e1c5aca-6f1d-4e22-8716-d44e9b47b6c2" targetNamespace="http://schemas.microsoft.com/office/2006/metadata/properties" ma:root="true" ma:fieldsID="9e6f634192e81de9c62830f3e2e111b9" ns2:_="" ns3:_="">
    <xsd:import namespace="8fddeaa3-4732-4488-9db6-a053d8348361"/>
    <xsd:import namespace="1e1c5aca-6f1d-4e22-8716-d44e9b47b6c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fddeaa3-4732-4488-9db6-a053d834836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5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1c5aca-6f1d-4e22-8716-d44e9b47b6c2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4A2DE463-8DB0-4B54-856B-D64E691B6320}">
  <ds:schemaRefs>
    <ds:schemaRef ds:uri="1e1c5aca-6f1d-4e22-8716-d44e9b47b6c2"/>
    <ds:schemaRef ds:uri="8fddeaa3-4732-4488-9db6-a053d8348361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A1FEBCE7-588F-4955-92A7-D1F6B9EFD98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4CC28CF-5DF1-4945-B272-58826E5B6903}">
  <ds:schemaRefs>
    <ds:schemaRef ds:uri="http://schemas.microsoft.com/office/infopath/2007/PartnerControls"/>
    <ds:schemaRef ds:uri="http://purl.org/dc/elements/1.1/"/>
    <ds:schemaRef ds:uri="http://www.w3.org/XML/1998/namespace"/>
    <ds:schemaRef ds:uri="http://schemas.microsoft.com/office/2006/documentManagement/types"/>
    <ds:schemaRef ds:uri="http://purl.org/dc/dcmitype/"/>
    <ds:schemaRef ds:uri="http://schemas.microsoft.com/office/2006/metadata/properties"/>
    <ds:schemaRef ds:uri="http://schemas.openxmlformats.org/package/2006/metadata/core-properties"/>
    <ds:schemaRef ds:uri="1e1c5aca-6f1d-4e22-8716-d44e9b47b6c2"/>
    <ds:schemaRef ds:uri="8fddeaa3-4732-4488-9db6-a053d8348361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PowerPoint Theme  - WFSOM</Template>
  <TotalTime>0</TotalTime>
  <Words>758</Words>
  <PresentationFormat>Widescreen</PresentationFormat>
  <Paragraphs>135</Paragraphs>
  <Slides>10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7</vt:i4>
      </vt:variant>
      <vt:variant>
        <vt:lpstr>Slide Titles</vt:lpstr>
      </vt:variant>
      <vt:variant>
        <vt:i4>10</vt:i4>
      </vt:variant>
    </vt:vector>
  </HeadingPairs>
  <TitlesOfParts>
    <vt:vector size="23" baseType="lpstr">
      <vt:lpstr>Arial</vt:lpstr>
      <vt:lpstr>Book Antiqua</vt:lpstr>
      <vt:lpstr>Calibri</vt:lpstr>
      <vt:lpstr>Times New Roman</vt:lpstr>
      <vt:lpstr>Trebuchet MS</vt:lpstr>
      <vt:lpstr>Wingdings</vt:lpstr>
      <vt:lpstr>PowerPoint Theme  - WFSOM</vt:lpstr>
      <vt:lpstr>Default Design</vt:lpstr>
      <vt:lpstr>1_Default Design</vt:lpstr>
      <vt:lpstr>Wake Forest Baptist Health PPT Theme</vt:lpstr>
      <vt:lpstr>2_Default Design</vt:lpstr>
      <vt:lpstr>3_Default Design</vt:lpstr>
      <vt:lpstr>1_PowerPoint Theme  - WFSOM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03T22:16:10Z</dcterms:created>
  <dcterms:modified xsi:type="dcterms:W3CDTF">2022-02-03T21:36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ACC25D49F2F4B4489B9721A466FDF4D</vt:lpwstr>
  </property>
</Properties>
</file>